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media/image29.png" ContentType="image/png"/>
  <Override PartName="/ppt/media/image21.jpeg" ContentType="image/jpeg"/>
  <Override PartName="/ppt/media/image4.jpeg" ContentType="image/jpeg"/>
  <Override PartName="/ppt/media/image2.png" ContentType="image/png"/>
  <Override PartName="/ppt/media/image25.jpeg" ContentType="image/jpeg"/>
  <Override PartName="/ppt/media/image9.jpeg" ContentType="image/jpeg"/>
  <Override PartName="/ppt/media/image11.jpeg" ContentType="image/jpeg"/>
  <Override PartName="/ppt/media/image6.jpeg" ContentType="image/jpeg"/>
  <Override PartName="/ppt/media/image10.jpeg" ContentType="image/jpeg"/>
  <Override PartName="/ppt/media/image8.jpeg" ContentType="image/jpeg"/>
  <Override PartName="/ppt/media/image30.png" ContentType="image/png"/>
  <Override PartName="/ppt/media/image28.png" ContentType="image/png"/>
  <Override PartName="/ppt/media/image7.jpeg" ContentType="image/jpeg"/>
  <Override PartName="/ppt/media/image12.jpeg" ContentType="image/jpeg"/>
  <Override PartName="/ppt/media/image5.jpeg" ContentType="image/jpeg"/>
  <Override PartName="/ppt/media/image26.jpeg" ContentType="image/jpeg"/>
  <Override PartName="/ppt/media/image13.jpeg" ContentType="image/jpeg"/>
  <Override PartName="/ppt/media/image3.png" ContentType="image/png"/>
  <Override PartName="/ppt/media/image17.jpeg" ContentType="image/jpeg"/>
  <Override PartName="/ppt/media/image31.png" ContentType="image/png"/>
  <Override PartName="/ppt/media/image1.png" ContentType="image/png"/>
  <Override PartName="/ppt/media/image14.jpeg" ContentType="image/jpeg"/>
  <Override PartName="/ppt/media/image15.jpeg" ContentType="image/jpeg"/>
  <Override PartName="/ppt/media/image16.jpeg" ContentType="image/jpeg"/>
  <Override PartName="/ppt/media/image18.jpeg" ContentType="image/jpeg"/>
  <Override PartName="/ppt/media/image19.jpeg" ContentType="image/jpeg"/>
  <Override PartName="/ppt/media/image20.jpeg" ContentType="image/jpeg"/>
  <Override PartName="/ppt/media/image22.jpeg" ContentType="image/jpeg"/>
  <Override PartName="/ppt/media/image23.jpeg" ContentType="image/jpeg"/>
  <Override PartName="/ppt/media/image24.jpeg" ContentType="image/jpeg"/>
  <Override PartName="/ppt/media/image27.png" ContentType="image/png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_rels/slide19.xml.rels" ContentType="application/vnd.openxmlformats-package.relationships+xml"/>
  <Override PartName="/ppt/slides/_rels/slide13.xml.rels" ContentType="application/vnd.openxmlformats-package.relationships+xml"/>
  <Override PartName="/ppt/slides/_rels/slide18.xml.rels" ContentType="application/vnd.openxmlformats-package.relationships+xml"/>
  <Override PartName="/ppt/slides/_rels/slide12.xml.rels" ContentType="application/vnd.openxmlformats-package.relationships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4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_rels/slide14.xml.rels" ContentType="application/vnd.openxmlformats-package.relationships+xml"/>
  <Override PartName="/ppt/slides/_rels/slide23.xml.rels" ContentType="application/vnd.openxmlformats-package.relationships+xml"/>
  <Override PartName="/ppt/slides/_rels/slide38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2.xml.rels" ContentType="application/vnd.openxmlformats-package.relationships+xml"/>
  <Override PartName="/ppt/slides/_rels/slide37.xml.rels" ContentType="application/vnd.openxmlformats-package.relationships+xml"/>
  <Override PartName="/ppt/slides/_rels/slide28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24.xml.rels" ContentType="application/vnd.openxmlformats-package.relationships+xml"/>
  <Override PartName="/ppt/slides/_rels/slide21.xml.rels" ContentType="application/vnd.openxmlformats-package.relationships+xml"/>
  <Override PartName="/ppt/slides/_rels/slide36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8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32.xml.rels" ContentType="application/vnd.openxmlformats-package.relationships+xml"/>
  <Override PartName="/ppt/slides/_rels/slide16.xml.rels" ContentType="application/vnd.openxmlformats-package.relationships+xml"/>
  <Override PartName="/ppt/slides/_rels/slide35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7.xml.rels" ContentType="application/vnd.openxmlformats-package.relationships+xml"/>
  <Override PartName="/ppt/slides/_rels/slide34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33.xml.rels" ContentType="application/vnd.openxmlformats-package.relationships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13.xml" ContentType="application/vnd.openxmlformats-officedocument.presentationml.slide+xml"/>
  <Override PartName="/ppt/slides/slide37.xml" ContentType="application/vnd.openxmlformats-officedocument.presentationml.slide+xml"/>
  <Override PartName="/ppt/slides/slide1.xml" ContentType="application/vnd.openxmlformats-officedocument.presentationml.slide+xml"/>
  <Override PartName="/ppt/slides/slide38.xml" ContentType="application/vnd.openxmlformats-officedocument.presentationml.slide+xml"/>
  <Override PartName="/ppt/slides/slide2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0.xml" ContentType="application/vnd.openxmlformats-officedocument.presentationml.slide+xml"/>
  <Override PartName="/ppt/slides/slide1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</p:sldIdLst>
  <p:sldSz cx="9144000" cy="6858000"/>
  <p:notesSz cx="6858000" cy="99472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79704FF-0022-4B6D-A1E5-EFF0E1CFE4DC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971360"/>
            <a:ext cx="830592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57200" y="4200120"/>
            <a:ext cx="830592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5DDAED7-9BAA-49B8-9350-196654AFF9E9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971360"/>
            <a:ext cx="40532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713480" y="1971360"/>
            <a:ext cx="40532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457200" y="4200120"/>
            <a:ext cx="40532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713480" y="4200120"/>
            <a:ext cx="40532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60B8F42-9286-4861-A7BC-A7C1A8BB47E3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971360"/>
            <a:ext cx="26744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265920" y="1971360"/>
            <a:ext cx="26744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6074280" y="1971360"/>
            <a:ext cx="26744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57200" y="4200120"/>
            <a:ext cx="26744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265920" y="4200120"/>
            <a:ext cx="26744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6074280" y="4200120"/>
            <a:ext cx="26744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2052CA3-4AD9-4CA0-AFB0-57E81FC8B2EC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457200" y="1971360"/>
            <a:ext cx="8305920" cy="4267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14B055B-F087-4FE4-971A-88021DD0CBA6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971360"/>
            <a:ext cx="8305920" cy="426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FABDE51-7078-4801-9941-48A2D6A524AF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971360"/>
            <a:ext cx="4053240" cy="426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713480" y="1971360"/>
            <a:ext cx="4053240" cy="426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E2CE436-9896-4BDC-996B-E47533347888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D6F8E03-8E0D-4997-AEAC-BE023284C5D9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3180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D5FCD5D-AD75-46E2-8D3D-04FC0A2719BA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971360"/>
            <a:ext cx="40532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713480" y="1971360"/>
            <a:ext cx="4053240" cy="426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57200" y="4200120"/>
            <a:ext cx="40532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0FC8D7D-B76B-4601-8E3D-7266C0E0562B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971360"/>
            <a:ext cx="4053240" cy="426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713480" y="1971360"/>
            <a:ext cx="40532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713480" y="4200120"/>
            <a:ext cx="40532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AE42D93-5E22-4DE6-AB2A-CD0ADB74CA5F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971360"/>
            <a:ext cx="40532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713480" y="1971360"/>
            <a:ext cx="405324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4200120"/>
            <a:ext cx="8305920" cy="203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C59C92A-FE8E-4062-955D-1BAC70914894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971360"/>
            <a:ext cx="8305920" cy="426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SzPct val="100000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601"/>
              </a:spcBef>
              <a:buClr>
                <a:srgbClr val="3333cc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601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601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601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601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8334000" y="6616440"/>
            <a:ext cx="762120" cy="22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8795AF-7CD9-4698-8878-F76D3F3F9C69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"/>
          <p:cNvSpPr/>
          <p:nvPr/>
        </p:nvSpPr>
        <p:spPr>
          <a:xfrm>
            <a:off x="3124080" y="6507000"/>
            <a:ext cx="30481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"/>
          <p:cNvSpPr/>
          <p:nvPr/>
        </p:nvSpPr>
        <p:spPr>
          <a:xfrm>
            <a:off x="2556000" y="6640560"/>
            <a:ext cx="374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Supplemental material for MetaMine analysi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Base" hidden="1"/>
          <p:cNvSpPr/>
          <p:nvPr/>
        </p:nvSpPr>
        <p:spPr>
          <a:xfrm>
            <a:off x="1523880" y="1397160"/>
            <a:ext cx="6096240" cy="40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slide" Target="slide30.xml"/><Relationship Id="rId3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slide" Target="slide31.xml"/><Relationship Id="rId3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slide" Target="slide28.xml"/><Relationship Id="rId3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slide" Target="slide30.xml"/><Relationship Id="rId3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slide" Target="slide30.xml"/><Relationship Id="rId3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slide" Target="slide31.xml"/><Relationship Id="rId3" Type="http://schemas.openxmlformats.org/officeDocument/2006/relationships/slideLayout" Target="../slideLayouts/slideLayout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jpeg"/><Relationship Id="rId2" Type="http://schemas.openxmlformats.org/officeDocument/2006/relationships/slide" Target="slide29.xml"/><Relationship Id="rId3" Type="http://schemas.openxmlformats.org/officeDocument/2006/relationships/slideLayout" Target="../slideLayouts/slideLayout3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jpeg"/><Relationship Id="rId2" Type="http://schemas.openxmlformats.org/officeDocument/2006/relationships/slide" Target="slide30.xml"/><Relationship Id="rId3" Type="http://schemas.openxmlformats.org/officeDocument/2006/relationships/slideLayout" Target="../slideLayouts/slideLayout3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jpeg"/><Relationship Id="rId2" Type="http://schemas.openxmlformats.org/officeDocument/2006/relationships/slide" Target="slide30.xml"/><Relationship Id="rId3" Type="http://schemas.openxmlformats.org/officeDocument/2006/relationships/slideLayout" Target="../slideLayouts/slideLayout3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slide" Target="slide31.xml"/><Relationship Id="rId3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jpeg"/><Relationship Id="rId2" Type="http://schemas.openxmlformats.org/officeDocument/2006/relationships/slideLayout" Target="../slideLayouts/slideLayout3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jpeg"/><Relationship Id="rId2" Type="http://schemas.openxmlformats.org/officeDocument/2006/relationships/slideLayout" Target="../slideLayouts/slideLayout3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jpeg"/><Relationship Id="rId2" Type="http://schemas.openxmlformats.org/officeDocument/2006/relationships/slideLayout" Target="../slideLayouts/slideLayout3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jpeg"/><Relationship Id="rId2" Type="http://schemas.openxmlformats.org/officeDocument/2006/relationships/slideLayout" Target="../slideLayouts/slideLayout3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jpeg"/><Relationship Id="rId2" Type="http://schemas.openxmlformats.org/officeDocument/2006/relationships/slideLayout" Target="../slideLayouts/slideLayout3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5.jpeg"/><Relationship Id="rId2" Type="http://schemas.openxmlformats.org/officeDocument/2006/relationships/slideLayout" Target="../slideLayouts/slideLayout3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6.jpeg"/><Relationship Id="rId2" Type="http://schemas.openxmlformats.org/officeDocument/2006/relationships/slideLayout" Target="../slideLayouts/slideLayout3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3.png"/><Relationship Id="rId6" Type="http://schemas.openxmlformats.org/officeDocument/2006/relationships/slideLayout" Target="../slideLayouts/slideLayout3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image" Target="../media/image3.png"/><Relationship Id="rId4" Type="http://schemas.openxmlformats.org/officeDocument/2006/relationships/slide" Target="slide12.xml"/><Relationship Id="rId5" Type="http://schemas.openxmlformats.org/officeDocument/2006/relationships/slide" Target="slide4.xml"/><Relationship Id="rId6" Type="http://schemas.openxmlformats.org/officeDocument/2006/relationships/slide" Target="slide8.xml"/><Relationship Id="rId7" Type="http://schemas.openxmlformats.org/officeDocument/2006/relationships/slideLayout" Target="../slideLayouts/slideLayout3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slide" Target="slide16.xml"/><Relationship Id="rId6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slide" Target="slide4.xml"/><Relationship Id="rId4" Type="http://schemas.openxmlformats.org/officeDocument/2006/relationships/slide" Target="slide8.xml"/><Relationship Id="rId5" Type="http://schemas.openxmlformats.org/officeDocument/2006/relationships/slideLayout" Target="../slideLayouts/slideLayout3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image" Target="../media/image3.png"/><Relationship Id="rId4" Type="http://schemas.openxmlformats.org/officeDocument/2006/relationships/slide" Target="slide5.xml"/><Relationship Id="rId5" Type="http://schemas.openxmlformats.org/officeDocument/2006/relationships/slide" Target="slide14.xml"/><Relationship Id="rId6" Type="http://schemas.openxmlformats.org/officeDocument/2006/relationships/slide" Target="slide17.xml"/><Relationship Id="rId7" Type="http://schemas.openxmlformats.org/officeDocument/2006/relationships/slide" Target="slide9.xml"/><Relationship Id="rId8" Type="http://schemas.openxmlformats.org/officeDocument/2006/relationships/slide" Target="slide10.xml"/><Relationship Id="rId9" Type="http://schemas.openxmlformats.org/officeDocument/2006/relationships/slide" Target="slide6.xml"/><Relationship Id="rId10" Type="http://schemas.openxmlformats.org/officeDocument/2006/relationships/slide" Target="slide20.xml"/><Relationship Id="rId11" Type="http://schemas.openxmlformats.org/officeDocument/2006/relationships/slide" Target="slide23.xml"/><Relationship Id="rId12" Type="http://schemas.openxmlformats.org/officeDocument/2006/relationships/slide" Target="slide21.xml"/><Relationship Id="rId13" Type="http://schemas.openxmlformats.org/officeDocument/2006/relationships/slide" Target="slide18.xml"/><Relationship Id="rId14" Type="http://schemas.openxmlformats.org/officeDocument/2006/relationships/slide" Target="slide13.xml"/><Relationship Id="rId15" Type="http://schemas.openxmlformats.org/officeDocument/2006/relationships/slide" Target="slide24.xml"/><Relationship Id="rId16" Type="http://schemas.openxmlformats.org/officeDocument/2006/relationships/slideLayout" Target="../slideLayouts/slideLayout3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slide" Target="slide7.xml"/><Relationship Id="rId2" Type="http://schemas.openxmlformats.org/officeDocument/2006/relationships/slide" Target="slide11.xml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3.png"/><Relationship Id="rId6" Type="http://schemas.openxmlformats.org/officeDocument/2006/relationships/image" Target="../media/image3.png"/><Relationship Id="rId7" Type="http://schemas.openxmlformats.org/officeDocument/2006/relationships/slideLayout" Target="../slideLayouts/slideLayout3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slide" Target="slide26.xml"/><Relationship Id="rId2" Type="http://schemas.openxmlformats.org/officeDocument/2006/relationships/image" Target="../media/image3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3.png"/><Relationship Id="rId6" Type="http://schemas.openxmlformats.org/officeDocument/2006/relationships/slideLayout" Target="../slideLayouts/slideLayout3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image" Target="../media/image3.png"/><Relationship Id="rId4" Type="http://schemas.openxmlformats.org/officeDocument/2006/relationships/image" Target="../media/image27.png"/><Relationship Id="rId5" Type="http://schemas.openxmlformats.org/officeDocument/2006/relationships/slideLayout" Target="../slideLayouts/slideLayout3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3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3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3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3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" Target="slide3.xml"/><Relationship Id="rId3" Type="http://schemas.openxmlformats.org/officeDocument/2006/relationships/slide" Target="slide28.xml"/><Relationship Id="rId4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" Target="slide30.xml"/><Relationship Id="rId3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" Target="slide30.xml"/><Relationship Id="rId3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slide" Target="slide31.xml"/><Relationship Id="rId3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slide" Target="slide3.xml"/><Relationship Id="rId3" Type="http://schemas.openxmlformats.org/officeDocument/2006/relationships/slide" Target="slide28.xml"/><Relationship Id="rId4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" Target="slide30.xml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Supplemental material to MetaMine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/>
          </p:nvPr>
        </p:nvSpPr>
        <p:spPr>
          <a:xfrm>
            <a:off x="457200" y="1971360"/>
            <a:ext cx="8305920" cy="426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In the next slides, the patterns found for each gene sequence are shown and associated with a link (    )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Following this link a summary of the pattern is given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If the same pattern was found by different gene sequences, the individual patterns were merged into one consensus pattern, described by it‘s longest extension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494480" y="252108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B3C5FCA-8AAF-42D7-9C22-16C738A52F0A}" type="slidenum">
              <a:t>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" descr=""/>
          <p:cNvPicPr/>
          <p:nvPr/>
        </p:nvPicPr>
        <p:blipFill>
          <a:blip r:embed="rId1"/>
          <a:stretch/>
        </p:blipFill>
        <p:spPr>
          <a:xfrm>
            <a:off x="519120" y="150840"/>
            <a:ext cx="8085240" cy="6540480"/>
          </a:xfrm>
          <a:prstGeom prst="rect">
            <a:avLst/>
          </a:prstGeom>
          <a:ln w="0">
            <a:noFill/>
          </a:ln>
        </p:spPr>
      </p:pic>
      <p:sp>
        <p:nvSpPr>
          <p:cNvPr id="80" name=""/>
          <p:cNvSpPr/>
          <p:nvPr/>
        </p:nvSpPr>
        <p:spPr>
          <a:xfrm>
            <a:off x="3975120" y="57456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A-AAM30936: 5a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>
            <a:hlinkClick r:id="rId2" action="ppaction://hlinksldjump"/>
          </p:cNvPr>
          <p:cNvSpPr/>
          <p:nvPr/>
        </p:nvSpPr>
        <p:spPr>
          <a:xfrm>
            <a:off x="7632720" y="72720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1BA5B70-4FDC-4F97-92EB-6E5BDEFD834E}" type="slidenum">
              <a:t>10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" descr=""/>
          <p:cNvPicPr/>
          <p:nvPr/>
        </p:nvPicPr>
        <p:blipFill>
          <a:blip r:embed="rId1"/>
          <a:stretch/>
        </p:blipFill>
        <p:spPr>
          <a:xfrm>
            <a:off x="560520" y="106200"/>
            <a:ext cx="8115120" cy="6588360"/>
          </a:xfrm>
          <a:prstGeom prst="rect">
            <a:avLst/>
          </a:prstGeom>
          <a:ln w="0">
            <a:noFill/>
          </a:ln>
        </p:spPr>
      </p:pic>
      <p:sp>
        <p:nvSpPr>
          <p:cNvPr id="83" name=""/>
          <p:cNvSpPr/>
          <p:nvPr/>
        </p:nvSpPr>
        <p:spPr>
          <a:xfrm>
            <a:off x="4000680" y="50976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A-AAM30936: 5b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>
            <a:hlinkClick r:id="rId2" action="ppaction://hlinksldjump"/>
          </p:cNvPr>
          <p:cNvSpPr/>
          <p:nvPr/>
        </p:nvSpPr>
        <p:spPr>
          <a:xfrm>
            <a:off x="7658280" y="662040"/>
            <a:ext cx="304560" cy="15228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149" h="21600">
                <a:moveTo>
                  <a:pt x="0" y="0"/>
                </a:moveTo>
                <a:lnTo>
                  <a:pt x="43149" y="0"/>
                </a:lnTo>
                <a:lnTo>
                  <a:pt x="43149" y="21600"/>
                </a:lnTo>
                <a:lnTo>
                  <a:pt x="0" y="21600"/>
                </a:lnTo>
                <a:close/>
              </a:path>
              <a:path fill="lightenLess" w="43149" h="21600">
                <a:moveTo>
                  <a:pt x="0" y="0"/>
                </a:moveTo>
                <a:lnTo>
                  <a:pt x="43149" y="0"/>
                </a:lnTo>
                <a:lnTo>
                  <a:pt x="41749" y="1400"/>
                </a:lnTo>
                <a:lnTo>
                  <a:pt x="1400" y="1400"/>
                </a:lnTo>
                <a:close/>
              </a:path>
              <a:path fill="darken" w="43149" h="21600">
                <a:moveTo>
                  <a:pt x="43149" y="0"/>
                </a:moveTo>
                <a:lnTo>
                  <a:pt x="43149" y="21600"/>
                </a:lnTo>
                <a:lnTo>
                  <a:pt x="41749" y="20200"/>
                </a:lnTo>
                <a:lnTo>
                  <a:pt x="41749" y="1400"/>
                </a:lnTo>
                <a:close/>
              </a:path>
              <a:path fill="darkenLess" w="43149" h="21600">
                <a:moveTo>
                  <a:pt x="43149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749" y="20200"/>
                </a:lnTo>
                <a:close/>
              </a:path>
              <a:path fill="lighten" w="43149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149" h="21600">
                <a:moveTo>
                  <a:pt x="14568" y="3794"/>
                </a:moveTo>
                <a:lnTo>
                  <a:pt x="28581" y="10800"/>
                </a:lnTo>
                <a:lnTo>
                  <a:pt x="14568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937F49D-BE94-4DA9-B30F-F6940004AD84}" type="slidenum">
              <a:t>1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" descr=""/>
          <p:cNvPicPr/>
          <p:nvPr/>
        </p:nvPicPr>
        <p:blipFill>
          <a:blip r:embed="rId1"/>
          <a:stretch/>
        </p:blipFill>
        <p:spPr>
          <a:xfrm>
            <a:off x="615960" y="157320"/>
            <a:ext cx="7993080" cy="6486480"/>
          </a:xfrm>
          <a:prstGeom prst="rect">
            <a:avLst/>
          </a:prstGeom>
          <a:ln w="0">
            <a:noFill/>
          </a:ln>
        </p:spPr>
      </p:pic>
      <p:sp>
        <p:nvSpPr>
          <p:cNvPr id="86" name=""/>
          <p:cNvSpPr/>
          <p:nvPr/>
        </p:nvSpPr>
        <p:spPr>
          <a:xfrm>
            <a:off x="3978360" y="54936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B-AAM30940: 14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>
            <a:hlinkClick r:id="rId2" action="ppaction://hlinksldjump"/>
          </p:cNvPr>
          <p:cNvSpPr/>
          <p:nvPr/>
        </p:nvSpPr>
        <p:spPr>
          <a:xfrm>
            <a:off x="7711920" y="70164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41157A8-00CF-4552-8C37-101CF95696F6}" type="slidenum">
              <a:t>1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" descr=""/>
          <p:cNvPicPr/>
          <p:nvPr/>
        </p:nvPicPr>
        <p:blipFill>
          <a:blip r:embed="rId1"/>
          <a:stretch/>
        </p:blipFill>
        <p:spPr>
          <a:xfrm>
            <a:off x="468360" y="135000"/>
            <a:ext cx="8064360" cy="6556320"/>
          </a:xfrm>
          <a:prstGeom prst="rect">
            <a:avLst/>
          </a:prstGeom>
          <a:ln w="0">
            <a:noFill/>
          </a:ln>
        </p:spPr>
      </p:pic>
      <p:sp>
        <p:nvSpPr>
          <p:cNvPr id="89" name=""/>
          <p:cNvSpPr/>
          <p:nvPr/>
        </p:nvSpPr>
        <p:spPr>
          <a:xfrm>
            <a:off x="3886200" y="54612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B-AAM30940: 10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>
            <a:hlinkClick r:id="rId2" action="ppaction://hlinksldjump"/>
          </p:cNvPr>
          <p:cNvSpPr/>
          <p:nvPr/>
        </p:nvSpPr>
        <p:spPr>
          <a:xfrm>
            <a:off x="7543800" y="69840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3794"/>
                </a:moveTo>
                <a:lnTo>
                  <a:pt x="28556" y="10800"/>
                </a:lnTo>
                <a:lnTo>
                  <a:pt x="14543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623415A-FCEB-4308-B740-4B9F8B86E1E6}" type="slidenum">
              <a:t>1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" descr=""/>
          <p:cNvPicPr/>
          <p:nvPr/>
        </p:nvPicPr>
        <p:blipFill>
          <a:blip r:embed="rId1"/>
          <a:stretch/>
        </p:blipFill>
        <p:spPr>
          <a:xfrm>
            <a:off x="539640" y="147600"/>
            <a:ext cx="8064720" cy="6524640"/>
          </a:xfrm>
          <a:prstGeom prst="rect">
            <a:avLst/>
          </a:prstGeom>
          <a:ln w="0">
            <a:noFill/>
          </a:ln>
        </p:spPr>
      </p:pic>
      <p:sp>
        <p:nvSpPr>
          <p:cNvPr id="92" name=""/>
          <p:cNvSpPr/>
          <p:nvPr/>
        </p:nvSpPr>
        <p:spPr>
          <a:xfrm>
            <a:off x="3975120" y="54936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B-AAM30940: 5a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>
            <a:hlinkClick r:id="rId2" action="ppaction://hlinksldjump"/>
          </p:cNvPr>
          <p:cNvSpPr/>
          <p:nvPr/>
        </p:nvSpPr>
        <p:spPr>
          <a:xfrm>
            <a:off x="7632720" y="70164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6CC9DE0-E34C-40EA-A511-527CFC632D1E}" type="slidenum">
              <a:t>1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" descr=""/>
          <p:cNvPicPr/>
          <p:nvPr/>
        </p:nvPicPr>
        <p:blipFill>
          <a:blip r:embed="rId1"/>
          <a:stretch/>
        </p:blipFill>
        <p:spPr>
          <a:xfrm>
            <a:off x="590400" y="127080"/>
            <a:ext cx="8064720" cy="6546600"/>
          </a:xfrm>
          <a:prstGeom prst="rect">
            <a:avLst/>
          </a:prstGeom>
          <a:ln w="0">
            <a:noFill/>
          </a:ln>
        </p:spPr>
      </p:pic>
      <p:sp>
        <p:nvSpPr>
          <p:cNvPr id="95" name=""/>
          <p:cNvSpPr/>
          <p:nvPr/>
        </p:nvSpPr>
        <p:spPr>
          <a:xfrm>
            <a:off x="4000680" y="54612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B-AAM30940: 5b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>
            <a:hlinkClick r:id="rId2" action="ppaction://hlinksldjump"/>
          </p:cNvPr>
          <p:cNvSpPr/>
          <p:nvPr/>
        </p:nvSpPr>
        <p:spPr>
          <a:xfrm>
            <a:off x="7658280" y="698400"/>
            <a:ext cx="304560" cy="15264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48" h="21600">
                <a:moveTo>
                  <a:pt x="0" y="0"/>
                </a:moveTo>
                <a:lnTo>
                  <a:pt x="43048" y="0"/>
                </a:lnTo>
                <a:lnTo>
                  <a:pt x="43048" y="21600"/>
                </a:lnTo>
                <a:lnTo>
                  <a:pt x="0" y="21600"/>
                </a:lnTo>
                <a:close/>
              </a:path>
              <a:path fill="lightenLess" w="43048" h="21600">
                <a:moveTo>
                  <a:pt x="0" y="0"/>
                </a:moveTo>
                <a:lnTo>
                  <a:pt x="43048" y="0"/>
                </a:lnTo>
                <a:lnTo>
                  <a:pt x="41648" y="1400"/>
                </a:lnTo>
                <a:lnTo>
                  <a:pt x="1400" y="1400"/>
                </a:lnTo>
                <a:close/>
              </a:path>
              <a:path fill="darken" w="43048" h="21600">
                <a:moveTo>
                  <a:pt x="43048" y="0"/>
                </a:moveTo>
                <a:lnTo>
                  <a:pt x="43048" y="21600"/>
                </a:lnTo>
                <a:lnTo>
                  <a:pt x="41648" y="20200"/>
                </a:lnTo>
                <a:lnTo>
                  <a:pt x="41648" y="1400"/>
                </a:lnTo>
                <a:close/>
              </a:path>
              <a:path fill="darkenLess" w="43048" h="21600">
                <a:moveTo>
                  <a:pt x="4304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48" y="20200"/>
                </a:lnTo>
                <a:close/>
              </a:path>
              <a:path fill="lighten" w="4304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48" h="21600">
                <a:moveTo>
                  <a:pt x="14517" y="3794"/>
                </a:moveTo>
                <a:lnTo>
                  <a:pt x="28530" y="10800"/>
                </a:lnTo>
                <a:lnTo>
                  <a:pt x="14517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F1B1963-E7E0-4F49-8AC8-5C570BF58666}" type="slidenum">
              <a:t>1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" descr=""/>
          <p:cNvPicPr/>
          <p:nvPr/>
        </p:nvPicPr>
        <p:blipFill>
          <a:blip r:embed="rId1"/>
          <a:stretch/>
        </p:blipFill>
        <p:spPr>
          <a:xfrm>
            <a:off x="582480" y="155520"/>
            <a:ext cx="8026560" cy="6513480"/>
          </a:xfrm>
          <a:prstGeom prst="rect">
            <a:avLst/>
          </a:prstGeom>
          <a:ln w="0">
            <a:noFill/>
          </a:ln>
        </p:spPr>
      </p:pic>
      <p:sp>
        <p:nvSpPr>
          <p:cNvPr id="98" name=""/>
          <p:cNvSpPr/>
          <p:nvPr/>
        </p:nvSpPr>
        <p:spPr>
          <a:xfrm>
            <a:off x="3997440" y="55728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C-AAM30938: 14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>
            <a:hlinkClick r:id="rId2" action="ppaction://hlinksldjump"/>
          </p:cNvPr>
          <p:cNvSpPr/>
          <p:nvPr/>
        </p:nvSpPr>
        <p:spPr>
          <a:xfrm>
            <a:off x="7731000" y="70956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ED26522-8993-4F92-A2F1-0D8C65AEDE9D}" type="slidenum">
              <a:t>1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" descr=""/>
          <p:cNvPicPr/>
          <p:nvPr/>
        </p:nvPicPr>
        <p:blipFill>
          <a:blip r:embed="rId1"/>
          <a:stretch/>
        </p:blipFill>
        <p:spPr>
          <a:xfrm>
            <a:off x="565200" y="125280"/>
            <a:ext cx="8097840" cy="6566040"/>
          </a:xfrm>
          <a:prstGeom prst="rect">
            <a:avLst/>
          </a:prstGeom>
          <a:ln w="0">
            <a:noFill/>
          </a:ln>
        </p:spPr>
      </p:pic>
      <p:sp>
        <p:nvSpPr>
          <p:cNvPr id="101" name=""/>
          <p:cNvSpPr/>
          <p:nvPr/>
        </p:nvSpPr>
        <p:spPr>
          <a:xfrm>
            <a:off x="4025880" y="53172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C-AAM30938: 11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>
            <a:hlinkClick r:id="rId2" action="ppaction://hlinksldjump"/>
          </p:cNvPr>
          <p:cNvSpPr/>
          <p:nvPr/>
        </p:nvSpPr>
        <p:spPr>
          <a:xfrm>
            <a:off x="7607160" y="68436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9A37AF0-7B97-4B61-AD21-2139747170E8}" type="slidenum">
              <a:t>1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" descr=""/>
          <p:cNvPicPr/>
          <p:nvPr/>
        </p:nvPicPr>
        <p:blipFill>
          <a:blip r:embed="rId1"/>
          <a:stretch/>
        </p:blipFill>
        <p:spPr>
          <a:xfrm>
            <a:off x="531720" y="133200"/>
            <a:ext cx="8064720" cy="6545520"/>
          </a:xfrm>
          <a:prstGeom prst="rect">
            <a:avLst/>
          </a:prstGeom>
          <a:ln w="0">
            <a:noFill/>
          </a:ln>
        </p:spPr>
      </p:pic>
      <p:sp>
        <p:nvSpPr>
          <p:cNvPr id="104" name=""/>
          <p:cNvSpPr/>
          <p:nvPr/>
        </p:nvSpPr>
        <p:spPr>
          <a:xfrm>
            <a:off x="3975120" y="55728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C-AAM30938: 5a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>
            <a:hlinkClick r:id="rId2" action="ppaction://hlinksldjump"/>
          </p:cNvPr>
          <p:cNvSpPr/>
          <p:nvPr/>
        </p:nvSpPr>
        <p:spPr>
          <a:xfrm>
            <a:off x="7556400" y="70956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16FFB40-DD1B-4317-8C8E-618D00CC1D5F}" type="slidenum">
              <a:t>1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" descr=""/>
          <p:cNvPicPr/>
          <p:nvPr/>
        </p:nvPicPr>
        <p:blipFill>
          <a:blip r:embed="rId1"/>
          <a:stretch/>
        </p:blipFill>
        <p:spPr>
          <a:xfrm>
            <a:off x="582480" y="108000"/>
            <a:ext cx="8064720" cy="6545160"/>
          </a:xfrm>
          <a:prstGeom prst="rect">
            <a:avLst/>
          </a:prstGeom>
          <a:ln w="0">
            <a:noFill/>
          </a:ln>
        </p:spPr>
      </p:pic>
      <p:sp>
        <p:nvSpPr>
          <p:cNvPr id="107" name=""/>
          <p:cNvSpPr/>
          <p:nvPr/>
        </p:nvSpPr>
        <p:spPr>
          <a:xfrm>
            <a:off x="4032360" y="53172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C-AAM30938: 5b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>
            <a:hlinkClick r:id="rId2" action="ppaction://hlinksldjump"/>
          </p:cNvPr>
          <p:cNvSpPr/>
          <p:nvPr/>
        </p:nvSpPr>
        <p:spPr>
          <a:xfrm>
            <a:off x="7613640" y="68436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63F59B4-2BFE-4E1B-9D0D-6434894850A4}" type="slidenum">
              <a:t>19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123840" y="2071800"/>
            <a:ext cx="8715240" cy="441936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228600" y="1415880"/>
            <a:ext cx="8305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 u="sng">
                <a:solidFill>
                  <a:srgbClr val="000000"/>
                </a:solidFill>
                <a:uFillTx/>
                <a:latin typeface="Arial"/>
              </a:rPr>
              <a:t>Key genes from:</a:t>
            </a: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 Hallam et. al., Reverse Methanogenesis: Testing the Hypothesis with Environmental Genomics, Science 305, 1457 (2004)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539640" y="582120"/>
            <a:ext cx="835344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Analysis of Methanogenesis and AOM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788000" y="2984400"/>
            <a:ext cx="431640" cy="0"/>
          </a:xfrm>
          <a:prstGeom prst="line">
            <a:avLst/>
          </a:prstGeom>
          <a:ln w="19080">
            <a:solidFill>
              <a:srgbClr val="fd1d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784760" y="3103560"/>
            <a:ext cx="431640" cy="0"/>
          </a:xfrm>
          <a:prstGeom prst="line">
            <a:avLst/>
          </a:prstGeom>
          <a:ln w="19080">
            <a:solidFill>
              <a:srgbClr val="fd1d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5470560" y="3103560"/>
            <a:ext cx="431640" cy="0"/>
          </a:xfrm>
          <a:prstGeom prst="line">
            <a:avLst/>
          </a:prstGeom>
          <a:ln w="19080">
            <a:solidFill>
              <a:srgbClr val="fd1d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6156360" y="3103560"/>
            <a:ext cx="431640" cy="0"/>
          </a:xfrm>
          <a:prstGeom prst="line">
            <a:avLst/>
          </a:prstGeom>
          <a:ln w="19080">
            <a:solidFill>
              <a:srgbClr val="fd1d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6813720" y="3103560"/>
            <a:ext cx="431640" cy="0"/>
          </a:xfrm>
          <a:prstGeom prst="line">
            <a:avLst/>
          </a:prstGeom>
          <a:ln w="19080">
            <a:solidFill>
              <a:srgbClr val="fd1d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7496280" y="3103560"/>
            <a:ext cx="431640" cy="0"/>
          </a:xfrm>
          <a:prstGeom prst="line">
            <a:avLst/>
          </a:prstGeom>
          <a:ln w="19080">
            <a:solidFill>
              <a:srgbClr val="fd1d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8172360" y="3103560"/>
            <a:ext cx="432000" cy="0"/>
          </a:xfrm>
          <a:prstGeom prst="line">
            <a:avLst/>
          </a:prstGeom>
          <a:ln w="19080">
            <a:solidFill>
              <a:srgbClr val="fd1d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41C18A1-A118-45B8-86F3-106F1C02663F}" type="slidenum">
              <a:t>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" descr=""/>
          <p:cNvPicPr/>
          <p:nvPr/>
        </p:nvPicPr>
        <p:blipFill>
          <a:blip r:embed="rId1"/>
          <a:stretch/>
        </p:blipFill>
        <p:spPr>
          <a:xfrm>
            <a:off x="547560" y="176040"/>
            <a:ext cx="7993080" cy="6492960"/>
          </a:xfrm>
          <a:prstGeom prst="rect">
            <a:avLst/>
          </a:prstGeom>
          <a:ln w="0">
            <a:noFill/>
          </a:ln>
        </p:spPr>
      </p:pic>
      <p:sp>
        <p:nvSpPr>
          <p:cNvPr id="110" name=""/>
          <p:cNvSpPr/>
          <p:nvPr/>
        </p:nvSpPr>
        <p:spPr>
          <a:xfrm>
            <a:off x="4029120" y="58248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D-AAM30939: 11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7610400" y="73512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3FD63DF-A296-4232-BB20-C2C16708E0AA}" type="slidenum">
              <a:t>20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" descr=""/>
          <p:cNvPicPr/>
          <p:nvPr/>
        </p:nvPicPr>
        <p:blipFill>
          <a:blip r:embed="rId1"/>
          <a:stretch/>
        </p:blipFill>
        <p:spPr>
          <a:xfrm>
            <a:off x="603360" y="182520"/>
            <a:ext cx="7993080" cy="6486480"/>
          </a:xfrm>
          <a:prstGeom prst="rect">
            <a:avLst/>
          </a:prstGeom>
          <a:ln w="0">
            <a:noFill/>
          </a:ln>
        </p:spPr>
      </p:pic>
      <p:sp>
        <p:nvSpPr>
          <p:cNvPr id="113" name=""/>
          <p:cNvSpPr/>
          <p:nvPr/>
        </p:nvSpPr>
        <p:spPr>
          <a:xfrm>
            <a:off x="4140360" y="59544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D-AAM30939: 5a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7721640" y="74772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49336B8-CBB0-4B6A-AD3E-3B1210137756}" type="slidenum">
              <a:t>2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" name="" descr=""/>
          <p:cNvPicPr/>
          <p:nvPr/>
        </p:nvPicPr>
        <p:blipFill>
          <a:blip r:embed="rId1"/>
          <a:stretch/>
        </p:blipFill>
        <p:spPr>
          <a:xfrm>
            <a:off x="623880" y="155520"/>
            <a:ext cx="7993080" cy="6488280"/>
          </a:xfrm>
          <a:prstGeom prst="rect">
            <a:avLst/>
          </a:prstGeom>
          <a:ln w="0">
            <a:noFill/>
          </a:ln>
        </p:spPr>
      </p:pic>
      <p:sp>
        <p:nvSpPr>
          <p:cNvPr id="116" name=""/>
          <p:cNvSpPr/>
          <p:nvPr/>
        </p:nvSpPr>
        <p:spPr>
          <a:xfrm>
            <a:off x="3863880" y="544680"/>
            <a:ext cx="3810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G-AAM30937: 14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7597800" y="69696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B2CB320-896F-4447-8ADF-F33A4983E250}" type="slidenum">
              <a:t>2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" descr=""/>
          <p:cNvPicPr/>
          <p:nvPr/>
        </p:nvPicPr>
        <p:blipFill>
          <a:blip r:embed="rId1"/>
          <a:stretch/>
        </p:blipFill>
        <p:spPr>
          <a:xfrm>
            <a:off x="565200" y="176040"/>
            <a:ext cx="7993080" cy="6486840"/>
          </a:xfrm>
          <a:prstGeom prst="rect">
            <a:avLst/>
          </a:prstGeom>
          <a:ln w="0">
            <a:noFill/>
          </a:ln>
        </p:spPr>
      </p:pic>
      <p:sp>
        <p:nvSpPr>
          <p:cNvPr id="119" name=""/>
          <p:cNvSpPr/>
          <p:nvPr/>
        </p:nvSpPr>
        <p:spPr>
          <a:xfrm>
            <a:off x="3825720" y="579600"/>
            <a:ext cx="3810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G-AAM30937: 11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7407360" y="731880"/>
            <a:ext cx="304560" cy="15228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149" h="21600">
                <a:moveTo>
                  <a:pt x="0" y="0"/>
                </a:moveTo>
                <a:lnTo>
                  <a:pt x="43149" y="0"/>
                </a:lnTo>
                <a:lnTo>
                  <a:pt x="43149" y="21600"/>
                </a:lnTo>
                <a:lnTo>
                  <a:pt x="0" y="21600"/>
                </a:lnTo>
                <a:close/>
              </a:path>
              <a:path fill="lightenLess" w="43149" h="21600">
                <a:moveTo>
                  <a:pt x="0" y="0"/>
                </a:moveTo>
                <a:lnTo>
                  <a:pt x="43149" y="0"/>
                </a:lnTo>
                <a:lnTo>
                  <a:pt x="41749" y="1400"/>
                </a:lnTo>
                <a:lnTo>
                  <a:pt x="1400" y="1400"/>
                </a:lnTo>
                <a:close/>
              </a:path>
              <a:path fill="darken" w="43149" h="21600">
                <a:moveTo>
                  <a:pt x="43149" y="0"/>
                </a:moveTo>
                <a:lnTo>
                  <a:pt x="43149" y="21600"/>
                </a:lnTo>
                <a:lnTo>
                  <a:pt x="41749" y="20200"/>
                </a:lnTo>
                <a:lnTo>
                  <a:pt x="41749" y="1400"/>
                </a:lnTo>
                <a:close/>
              </a:path>
              <a:path fill="darkenLess" w="43149" h="21600">
                <a:moveTo>
                  <a:pt x="43149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749" y="20200"/>
                </a:lnTo>
                <a:close/>
              </a:path>
              <a:path fill="lighten" w="43149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149" h="21600">
                <a:moveTo>
                  <a:pt x="14568" y="3794"/>
                </a:moveTo>
                <a:lnTo>
                  <a:pt x="28581" y="10800"/>
                </a:lnTo>
                <a:lnTo>
                  <a:pt x="14568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7CD6336-72C5-4555-AEBF-D05FF94F0D9E}" type="slidenum">
              <a:t>2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" descr=""/>
          <p:cNvPicPr/>
          <p:nvPr/>
        </p:nvPicPr>
        <p:blipFill>
          <a:blip r:embed="rId1"/>
          <a:stretch/>
        </p:blipFill>
        <p:spPr>
          <a:xfrm>
            <a:off x="633240" y="142920"/>
            <a:ext cx="7993080" cy="6514920"/>
          </a:xfrm>
          <a:prstGeom prst="rect">
            <a:avLst/>
          </a:prstGeom>
          <a:ln w="0">
            <a:noFill/>
          </a:ln>
        </p:spPr>
      </p:pic>
      <p:sp>
        <p:nvSpPr>
          <p:cNvPr id="122" name=""/>
          <p:cNvSpPr/>
          <p:nvPr/>
        </p:nvSpPr>
        <p:spPr>
          <a:xfrm>
            <a:off x="3927600" y="55404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G-AAM30937: 5a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7508880" y="70632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3794"/>
                </a:moveTo>
                <a:lnTo>
                  <a:pt x="28556" y="10800"/>
                </a:lnTo>
                <a:lnTo>
                  <a:pt x="14543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E05E60C-F599-4BC0-8255-CAB6E200002D}" type="slidenum">
              <a:t>2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" descr=""/>
          <p:cNvPicPr/>
          <p:nvPr/>
        </p:nvPicPr>
        <p:blipFill>
          <a:blip r:embed="rId1"/>
          <a:stretch/>
        </p:blipFill>
        <p:spPr>
          <a:xfrm>
            <a:off x="590400" y="182520"/>
            <a:ext cx="7993080" cy="6488280"/>
          </a:xfrm>
          <a:prstGeom prst="rect">
            <a:avLst/>
          </a:prstGeom>
          <a:ln w="0">
            <a:noFill/>
          </a:ln>
        </p:spPr>
      </p:pic>
      <p:sp>
        <p:nvSpPr>
          <p:cNvPr id="125" name=""/>
          <p:cNvSpPr/>
          <p:nvPr/>
        </p:nvSpPr>
        <p:spPr>
          <a:xfrm>
            <a:off x="3832200" y="58248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G-AAM30937: 5b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7413480" y="73512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BD9646F-A10C-4E52-B525-DEB94BE48513}" type="slidenum">
              <a:t>2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" descr=""/>
          <p:cNvPicPr/>
          <p:nvPr/>
        </p:nvPicPr>
        <p:blipFill>
          <a:blip r:embed="rId1"/>
          <a:stretch/>
        </p:blipFill>
        <p:spPr>
          <a:xfrm>
            <a:off x="611280" y="174600"/>
            <a:ext cx="7993080" cy="6485040"/>
          </a:xfrm>
          <a:prstGeom prst="rect">
            <a:avLst/>
          </a:prstGeom>
          <a:ln w="0">
            <a:noFill/>
          </a:ln>
        </p:spPr>
      </p:pic>
      <p:sp>
        <p:nvSpPr>
          <p:cNvPr id="128" name=""/>
          <p:cNvSpPr/>
          <p:nvPr/>
        </p:nvSpPr>
        <p:spPr>
          <a:xfrm>
            <a:off x="4070520" y="60660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rtC-AAM30613: 17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7804080" y="75888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2F5F6CD-FE7F-43A4-9B9C-0963D3280646}" type="slidenum">
              <a:t>2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Summary for Methanogenesis and AOM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57200" y="1676160"/>
            <a:ext cx="8305920" cy="456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Analysed genes: mcrA, mcrB, mcrC, mcrD, mcrG, mrt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Patterns found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1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mcrA-14pattern </a:t>
            </a:r>
            <a:r>
              <a:rPr b="0" lang="de-DE" sz="2000" spc="-1" strike="noStrike">
                <a:solidFill>
                  <a:srgbClr val="000000"/>
                </a:solidFill>
                <a:latin typeface="Symbol"/>
                <a:ea typeface="Symbol"/>
              </a:rPr>
              <a:t>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mcrB-14  </a:t>
            </a:r>
            <a:r>
              <a:rPr b="0" lang="de-DE" sz="2000" spc="-1" strike="noStrike">
                <a:solidFill>
                  <a:srgbClr val="000000"/>
                </a:solidFill>
                <a:latin typeface="Symbol"/>
                <a:ea typeface="Symbol"/>
              </a:rPr>
              <a:t>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mcrG-1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mcrC-14patter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3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mcrA-11 </a:t>
            </a:r>
            <a:r>
              <a:rPr b="0" lang="de-DE" sz="2000" spc="-1" strike="noStrike">
                <a:solidFill>
                  <a:srgbClr val="000000"/>
                </a:solidFill>
                <a:latin typeface="Symbol"/>
                <a:ea typeface="Symbol"/>
              </a:rPr>
              <a:t>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mcrA5a </a:t>
            </a:r>
            <a:r>
              <a:rPr b="0" lang="de-DE" sz="2000" spc="-1" strike="noStrike">
                <a:solidFill>
                  <a:srgbClr val="000000"/>
                </a:solidFill>
                <a:latin typeface="Symbol"/>
                <a:ea typeface="Symbol"/>
              </a:rPr>
              <a:t>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mcrB-5a </a:t>
            </a:r>
            <a:r>
              <a:rPr b="0" lang="de-DE" sz="2000" spc="-1" strike="noStrike">
                <a:solidFill>
                  <a:srgbClr val="000000"/>
                </a:solidFill>
                <a:latin typeface="Symbol"/>
                <a:ea typeface="Symbol"/>
              </a:rPr>
              <a:t>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mcrC-5 </a:t>
            </a:r>
            <a:r>
              <a:rPr b="0" lang="de-DE" sz="2000" spc="-1" strike="noStrike">
                <a:solidFill>
                  <a:srgbClr val="000000"/>
                </a:solidFill>
                <a:latin typeface="Symbol"/>
                <a:ea typeface="Symbol"/>
              </a:rPr>
              <a:t>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mcrD-11 </a:t>
            </a:r>
            <a:r>
              <a:rPr b="0" lang="de-DE" sz="2000" spc="-1" strike="noStrike">
                <a:solidFill>
                  <a:srgbClr val="000000"/>
                </a:solidFill>
                <a:latin typeface="Symbol"/>
                <a:ea typeface="Symbol"/>
              </a:rPr>
              <a:t>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mcrG-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4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mcrA-5b </a:t>
            </a:r>
            <a:r>
              <a:rPr b="0" lang="de-DE" sz="2000" spc="-1" strike="noStrike">
                <a:solidFill>
                  <a:srgbClr val="000000"/>
                </a:solidFill>
                <a:latin typeface="Symbol"/>
                <a:ea typeface="Symbol"/>
              </a:rPr>
              <a:t>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mcrB-5b </a:t>
            </a:r>
            <a:r>
              <a:rPr b="0" lang="de-DE" sz="2000" spc="-1" strike="noStrike">
                <a:solidFill>
                  <a:srgbClr val="000000"/>
                </a:solidFill>
                <a:latin typeface="Symbol"/>
                <a:ea typeface="Symbol"/>
              </a:rPr>
              <a:t>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mcrC-6 </a:t>
            </a:r>
            <a:r>
              <a:rPr b="0" lang="de-DE" sz="2000" spc="-1" strike="noStrike">
                <a:solidFill>
                  <a:srgbClr val="000000"/>
                </a:solidFill>
                <a:latin typeface="Symbol"/>
                <a:ea typeface="Symbol"/>
              </a:rPr>
              <a:t>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mcrG-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5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mrtC-17patter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50EB366-8730-482C-B5DA-C4D5006E1325}" type="slidenum">
              <a:t>2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"/>
          <p:cNvSpPr/>
          <p:nvPr/>
        </p:nvSpPr>
        <p:spPr>
          <a:xfrm>
            <a:off x="457200" y="3933720"/>
            <a:ext cx="419040" cy="228600"/>
          </a:xfrm>
          <a:prstGeom prst="rect">
            <a:avLst/>
          </a:prstGeom>
          <a:noFill/>
          <a:ln w="19080">
            <a:solidFill>
              <a:srgbClr val="00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876240" y="3933720"/>
            <a:ext cx="419040" cy="228600"/>
          </a:xfrm>
          <a:prstGeom prst="rect">
            <a:avLst/>
          </a:prstGeom>
          <a:noFill/>
          <a:ln w="19080">
            <a:solidFill>
              <a:srgbClr val="00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1295280" y="3933720"/>
            <a:ext cx="41940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171468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213372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255276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297180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339084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3809880" y="3933720"/>
            <a:ext cx="41940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422928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464832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506736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548640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590544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6324480" y="3933720"/>
            <a:ext cx="41940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674388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7162920" y="393372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7581960" y="3933720"/>
            <a:ext cx="419040" cy="228600"/>
          </a:xfrm>
          <a:prstGeom prst="rect">
            <a:avLst/>
          </a:prstGeom>
          <a:noFill/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8001000" y="3933720"/>
            <a:ext cx="419040" cy="228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8420040" y="3933720"/>
            <a:ext cx="419040" cy="228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334332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crB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457200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80964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428760" y="4680000"/>
            <a:ext cx="1295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onserved hypothetical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1219320" y="39337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164772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205740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2486160" y="39337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289548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3753000" y="39337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cr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4191120" y="39337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cr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502920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>
            <a:off x="541008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584820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6248520" y="39337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667692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708660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>
            <a:off x="752472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792468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833436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1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72" name=""/>
          <p:cNvCxnSpPr>
            <a:stCxn id="155" idx="0"/>
            <a:endCxn id="154" idx="2"/>
          </p:cNvCxnSpPr>
          <p:nvPr/>
        </p:nvCxnSpPr>
        <p:spPr>
          <a:xfrm flipV="1">
            <a:off x="1076040" y="4177800"/>
            <a:ext cx="1080" cy="502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73" name=""/>
          <p:cNvSpPr/>
          <p:nvPr/>
        </p:nvSpPr>
        <p:spPr>
          <a:xfrm>
            <a:off x="914400" y="5060880"/>
            <a:ext cx="1676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oenzyme PQQ synthesis protein (pqqE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74" name=""/>
          <p:cNvCxnSpPr>
            <a:stCxn id="173" idx="0"/>
            <a:endCxn id="156" idx="2"/>
          </p:cNvCxnSpPr>
          <p:nvPr/>
        </p:nvCxnSpPr>
        <p:spPr>
          <a:xfrm flipH="1" flipV="1">
            <a:off x="1485720" y="4177800"/>
            <a:ext cx="267120" cy="8834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5" name=""/>
          <p:cNvCxnSpPr>
            <a:stCxn id="155" idx="0"/>
            <a:endCxn id="176" idx="2"/>
          </p:cNvCxnSpPr>
          <p:nvPr/>
        </p:nvCxnSpPr>
        <p:spPr>
          <a:xfrm flipH="1" flipV="1">
            <a:off x="646920" y="4177800"/>
            <a:ext cx="429480" cy="502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77" name=""/>
          <p:cNvSpPr/>
          <p:nvPr/>
        </p:nvSpPr>
        <p:spPr>
          <a:xfrm>
            <a:off x="1828800" y="5686560"/>
            <a:ext cx="1676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rhodanese-like thiosulfate sulfurtransferas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78" name=""/>
          <p:cNvCxnSpPr>
            <a:stCxn id="177" idx="0"/>
            <a:endCxn id="158" idx="2"/>
          </p:cNvCxnSpPr>
          <p:nvPr/>
        </p:nvCxnSpPr>
        <p:spPr>
          <a:xfrm flipH="1" flipV="1">
            <a:off x="2323800" y="4177800"/>
            <a:ext cx="343440" cy="150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76" name=""/>
          <p:cNvSpPr/>
          <p:nvPr/>
        </p:nvSpPr>
        <p:spPr>
          <a:xfrm>
            <a:off x="380880" y="3933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79" name=""/>
          <p:cNvCxnSpPr>
            <a:stCxn id="155" idx="0"/>
            <a:endCxn id="157" idx="2"/>
          </p:cNvCxnSpPr>
          <p:nvPr/>
        </p:nvCxnSpPr>
        <p:spPr>
          <a:xfrm flipV="1">
            <a:off x="1076400" y="4177800"/>
            <a:ext cx="838800" cy="502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80" name=""/>
          <p:cNvSpPr/>
          <p:nvPr/>
        </p:nvSpPr>
        <p:spPr>
          <a:xfrm>
            <a:off x="2590920" y="5076720"/>
            <a:ext cx="1676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redicted protease of the collagenase family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81" name=""/>
          <p:cNvCxnSpPr>
            <a:stCxn id="180" idx="0"/>
            <a:endCxn id="159" idx="2"/>
          </p:cNvCxnSpPr>
          <p:nvPr/>
        </p:nvCxnSpPr>
        <p:spPr>
          <a:xfrm flipH="1" flipV="1">
            <a:off x="2751840" y="4177800"/>
            <a:ext cx="677160" cy="8992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82" name=""/>
          <p:cNvSpPr/>
          <p:nvPr/>
        </p:nvSpPr>
        <p:spPr>
          <a:xfrm>
            <a:off x="2514600" y="4680000"/>
            <a:ext cx="16765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utative methyltransferas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83" name=""/>
          <p:cNvCxnSpPr>
            <a:stCxn id="182" idx="0"/>
            <a:endCxn id="160" idx="2"/>
          </p:cNvCxnSpPr>
          <p:nvPr/>
        </p:nvCxnSpPr>
        <p:spPr>
          <a:xfrm flipH="1" flipV="1">
            <a:off x="3161520" y="4177800"/>
            <a:ext cx="191160" cy="502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4" name=""/>
          <p:cNvCxnSpPr>
            <a:stCxn id="185" idx="0"/>
            <a:endCxn id="153" idx="2"/>
          </p:cNvCxnSpPr>
          <p:nvPr/>
        </p:nvCxnSpPr>
        <p:spPr>
          <a:xfrm flipH="1" flipV="1">
            <a:off x="4838760" y="4177800"/>
            <a:ext cx="7668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86" name=""/>
          <p:cNvSpPr/>
          <p:nvPr/>
        </p:nvSpPr>
        <p:spPr>
          <a:xfrm>
            <a:off x="4457880" y="5249880"/>
            <a:ext cx="1676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adenine deaminase (adeC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87" name=""/>
          <p:cNvCxnSpPr>
            <a:stCxn id="186" idx="0"/>
            <a:endCxn id="163" idx="2"/>
          </p:cNvCxnSpPr>
          <p:nvPr/>
        </p:nvCxnSpPr>
        <p:spPr>
          <a:xfrm flipV="1">
            <a:off x="5295600" y="4177440"/>
            <a:ext cx="1080" cy="10724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8" name=""/>
          <p:cNvCxnSpPr>
            <a:stCxn id="185" idx="0"/>
            <a:endCxn id="164" idx="2"/>
          </p:cNvCxnSpPr>
          <p:nvPr/>
        </p:nvCxnSpPr>
        <p:spPr>
          <a:xfrm flipV="1">
            <a:off x="4915080" y="4177800"/>
            <a:ext cx="76248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9" name=""/>
          <p:cNvCxnSpPr>
            <a:stCxn id="185" idx="0"/>
            <a:endCxn id="165" idx="2"/>
          </p:cNvCxnSpPr>
          <p:nvPr/>
        </p:nvCxnSpPr>
        <p:spPr>
          <a:xfrm flipV="1">
            <a:off x="4914720" y="4177800"/>
            <a:ext cx="120060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90" name=""/>
          <p:cNvSpPr/>
          <p:nvPr/>
        </p:nvSpPr>
        <p:spPr>
          <a:xfrm>
            <a:off x="5562720" y="4687920"/>
            <a:ext cx="10666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neumococcal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surface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91" name=""/>
          <p:cNvCxnSpPr>
            <a:stCxn id="190" idx="0"/>
            <a:endCxn id="166" idx="2"/>
          </p:cNvCxnSpPr>
          <p:nvPr/>
        </p:nvCxnSpPr>
        <p:spPr>
          <a:xfrm flipV="1">
            <a:off x="6095520" y="4177800"/>
            <a:ext cx="420120" cy="510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85" name=""/>
          <p:cNvSpPr/>
          <p:nvPr/>
        </p:nvSpPr>
        <p:spPr>
          <a:xfrm>
            <a:off x="4267080" y="4695840"/>
            <a:ext cx="129564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onserved hypothetical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92" name=""/>
          <p:cNvCxnSpPr>
            <a:stCxn id="193" idx="0"/>
            <a:endCxn id="167" idx="2"/>
          </p:cNvCxnSpPr>
          <p:nvPr/>
        </p:nvCxnSpPr>
        <p:spPr>
          <a:xfrm flipH="1" flipV="1">
            <a:off x="6942960" y="4177800"/>
            <a:ext cx="60084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94" name=""/>
          <p:cNvSpPr/>
          <p:nvPr/>
        </p:nvSpPr>
        <p:spPr>
          <a:xfrm>
            <a:off x="5257800" y="5686560"/>
            <a:ext cx="1447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ulticatalytic endopeptidase complex subunit alph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95" name=""/>
          <p:cNvCxnSpPr>
            <a:stCxn id="194" idx="0"/>
            <a:endCxn id="168" idx="2"/>
          </p:cNvCxnSpPr>
          <p:nvPr/>
        </p:nvCxnSpPr>
        <p:spPr>
          <a:xfrm flipV="1">
            <a:off x="5981760" y="4177800"/>
            <a:ext cx="1372320" cy="150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96" name=""/>
          <p:cNvCxnSpPr>
            <a:stCxn id="193" idx="0"/>
            <a:endCxn id="169" idx="2"/>
          </p:cNvCxnSpPr>
          <p:nvPr/>
        </p:nvCxnSpPr>
        <p:spPr>
          <a:xfrm flipV="1">
            <a:off x="7543800" y="4177800"/>
            <a:ext cx="24840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97" name=""/>
          <p:cNvSpPr/>
          <p:nvPr/>
        </p:nvSpPr>
        <p:spPr>
          <a:xfrm>
            <a:off x="6858000" y="5686560"/>
            <a:ext cx="1143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exosome complex RNA-binding protein 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98" name=""/>
          <p:cNvCxnSpPr>
            <a:stCxn id="197" idx="0"/>
            <a:endCxn id="170" idx="2"/>
          </p:cNvCxnSpPr>
          <p:nvPr/>
        </p:nvCxnSpPr>
        <p:spPr>
          <a:xfrm flipV="1">
            <a:off x="7429680" y="4177800"/>
            <a:ext cx="762480" cy="150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99" name=""/>
          <p:cNvCxnSpPr>
            <a:stCxn id="200" idx="0"/>
            <a:endCxn id="171" idx="2"/>
          </p:cNvCxnSpPr>
          <p:nvPr/>
        </p:nvCxnSpPr>
        <p:spPr>
          <a:xfrm flipV="1">
            <a:off x="8457840" y="4177800"/>
            <a:ext cx="143640" cy="9072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93" name=""/>
          <p:cNvSpPr/>
          <p:nvPr/>
        </p:nvSpPr>
        <p:spPr>
          <a:xfrm>
            <a:off x="6858000" y="4695840"/>
            <a:ext cx="137160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onserved hypothetical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PlaceHolder 1"/>
          <p:cNvSpPr>
            <a:spLocks noGrp="1"/>
          </p:cNvSpPr>
          <p:nvPr>
            <p:ph/>
          </p:nvPr>
        </p:nvSpPr>
        <p:spPr>
          <a:xfrm>
            <a:off x="228240" y="1143000"/>
            <a:ext cx="8915400" cy="5410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Samples: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1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3161 (AY714816), 3197 (AY714852), 3203 (AY714858),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3219 (BX649197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metagenome Eel River Basin, Slope of North-Western Crimera are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3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sediment, water depth levels 10-1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Longest extension with mismatches: </a:t>
            </a:r>
            <a:r>
              <a:rPr b="0" lang="de-DE" sz="2400" spc="-1" strike="noStrike">
                <a:solidFill>
                  <a:srgbClr val="000000"/>
                </a:solidFill>
                <a:latin typeface="Symbol"/>
                <a:ea typeface="Symbol"/>
              </a:rPr>
              <a:t></a:t>
            </a: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 length 2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2"/>
          <p:cNvSpPr>
            <a:spLocks noGrp="1"/>
          </p:cNvSpPr>
          <p:nvPr>
            <p:ph type="title"/>
          </p:nvPr>
        </p:nvSpPr>
        <p:spPr>
          <a:xfrm>
            <a:off x="685800" y="30456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mcr</a:t>
            </a:r>
            <a:r>
              <a:rPr b="1" lang="de-DE" sz="2800" spc="-1" strike="noStrike">
                <a:solidFill>
                  <a:srgbClr val="009900"/>
                </a:solidFill>
                <a:latin typeface="Arial"/>
              </a:rPr>
              <a:t>B</a:t>
            </a: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/G/</a:t>
            </a:r>
            <a:r>
              <a:rPr b="1" lang="de-DE" sz="2800" spc="-1" strike="noStrike">
                <a:solidFill>
                  <a:srgbClr val="0000ff"/>
                </a:solidFill>
                <a:latin typeface="Arial"/>
              </a:rPr>
              <a:t>A</a:t>
            </a: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 - 14pattern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>
            <a:hlinkClick r:id="rId4" action="ppaction://hlinksldjump"/>
          </p:cNvPr>
          <p:cNvSpPr/>
          <p:nvPr/>
        </p:nvSpPr>
        <p:spPr>
          <a:xfrm>
            <a:off x="3352680" y="83808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10800"/>
                </a:moveTo>
                <a:lnTo>
                  <a:pt x="28556" y="3794"/>
                </a:lnTo>
                <a:lnTo>
                  <a:pt x="2855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>
            <a:off x="3733920" y="838080"/>
            <a:ext cx="304560" cy="15264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48" h="21600">
                <a:moveTo>
                  <a:pt x="0" y="0"/>
                </a:moveTo>
                <a:lnTo>
                  <a:pt x="43048" y="0"/>
                </a:lnTo>
                <a:lnTo>
                  <a:pt x="43048" y="21600"/>
                </a:lnTo>
                <a:lnTo>
                  <a:pt x="0" y="21600"/>
                </a:lnTo>
                <a:close/>
              </a:path>
              <a:path fill="lightenLess" w="43048" h="21600">
                <a:moveTo>
                  <a:pt x="0" y="0"/>
                </a:moveTo>
                <a:lnTo>
                  <a:pt x="43048" y="0"/>
                </a:lnTo>
                <a:lnTo>
                  <a:pt x="41648" y="1400"/>
                </a:lnTo>
                <a:lnTo>
                  <a:pt x="1400" y="1400"/>
                </a:lnTo>
                <a:close/>
              </a:path>
              <a:path fill="darken" w="43048" h="21600">
                <a:moveTo>
                  <a:pt x="43048" y="0"/>
                </a:moveTo>
                <a:lnTo>
                  <a:pt x="43048" y="21600"/>
                </a:lnTo>
                <a:lnTo>
                  <a:pt x="41648" y="20200"/>
                </a:lnTo>
                <a:lnTo>
                  <a:pt x="41648" y="1400"/>
                </a:lnTo>
                <a:close/>
              </a:path>
              <a:path fill="darkenLess" w="43048" h="21600">
                <a:moveTo>
                  <a:pt x="4304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48" y="20200"/>
                </a:lnTo>
                <a:close/>
              </a:path>
              <a:path fill="lighten" w="4304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48" h="21600">
                <a:moveTo>
                  <a:pt x="14517" y="10800"/>
                </a:moveTo>
                <a:lnTo>
                  <a:pt x="28530" y="3794"/>
                </a:lnTo>
                <a:lnTo>
                  <a:pt x="28530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>
            <a:hlinkClick r:id="rId5" action="ppaction://hlinksldjump"/>
          </p:cNvPr>
          <p:cNvSpPr/>
          <p:nvPr/>
        </p:nvSpPr>
        <p:spPr>
          <a:xfrm>
            <a:off x="4114800" y="83808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10800"/>
                </a:moveTo>
                <a:lnTo>
                  <a:pt x="28556" y="3794"/>
                </a:lnTo>
                <a:lnTo>
                  <a:pt x="2855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533520" y="609480"/>
            <a:ext cx="4730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>
            <a:off x="7848720" y="5084640"/>
            <a:ext cx="12189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ribonuclease PH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(rph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>
            <a:hlinkClick r:id="rId6" action="ppaction://hlinksldjump"/>
          </p:cNvPr>
          <p:cNvSpPr/>
          <p:nvPr/>
        </p:nvSpPr>
        <p:spPr>
          <a:xfrm>
            <a:off x="4114800" y="106668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10800"/>
                </a:moveTo>
                <a:lnTo>
                  <a:pt x="28556" y="3794"/>
                </a:lnTo>
                <a:lnTo>
                  <a:pt x="2855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03EFF43-233C-4EDF-88ED-6813F3A162BC}" type="slidenum">
              <a:t>2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PlaceHolder 1"/>
          <p:cNvSpPr>
            <a:spLocks noGrp="1"/>
          </p:cNvSpPr>
          <p:nvPr>
            <p:ph/>
          </p:nvPr>
        </p:nvSpPr>
        <p:spPr>
          <a:xfrm>
            <a:off x="228240" y="1143000"/>
            <a:ext cx="8915400" cy="5410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Samples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1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3161 (AY714816), 3197 (AY714852), 3203 (AY714858)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metagenome Eel River Basin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3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sediment, (520m / 9cm) dept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4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Length 1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2"/>
          <p:cNvSpPr>
            <a:spLocks noGrp="1"/>
          </p:cNvSpPr>
          <p:nvPr>
            <p:ph type="title"/>
          </p:nvPr>
        </p:nvSpPr>
        <p:spPr>
          <a:xfrm>
            <a:off x="685800" y="30456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mcrC - 14pattern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>
            <a:hlinkClick r:id="rId5" action="ppaction://hlinksldjump"/>
          </p:cNvPr>
          <p:cNvSpPr/>
          <p:nvPr/>
        </p:nvSpPr>
        <p:spPr>
          <a:xfrm>
            <a:off x="3733920" y="838080"/>
            <a:ext cx="304560" cy="15264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48" h="21600">
                <a:moveTo>
                  <a:pt x="0" y="0"/>
                </a:moveTo>
                <a:lnTo>
                  <a:pt x="43048" y="0"/>
                </a:lnTo>
                <a:lnTo>
                  <a:pt x="43048" y="21600"/>
                </a:lnTo>
                <a:lnTo>
                  <a:pt x="0" y="21600"/>
                </a:lnTo>
                <a:close/>
              </a:path>
              <a:path fill="lightenLess" w="43048" h="21600">
                <a:moveTo>
                  <a:pt x="0" y="0"/>
                </a:moveTo>
                <a:lnTo>
                  <a:pt x="43048" y="0"/>
                </a:lnTo>
                <a:lnTo>
                  <a:pt x="41648" y="1400"/>
                </a:lnTo>
                <a:lnTo>
                  <a:pt x="1400" y="1400"/>
                </a:lnTo>
                <a:close/>
              </a:path>
              <a:path fill="darken" w="43048" h="21600">
                <a:moveTo>
                  <a:pt x="43048" y="0"/>
                </a:moveTo>
                <a:lnTo>
                  <a:pt x="43048" y="21600"/>
                </a:lnTo>
                <a:lnTo>
                  <a:pt x="41648" y="20200"/>
                </a:lnTo>
                <a:lnTo>
                  <a:pt x="41648" y="1400"/>
                </a:lnTo>
                <a:close/>
              </a:path>
              <a:path fill="darkenLess" w="43048" h="21600">
                <a:moveTo>
                  <a:pt x="4304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48" y="20200"/>
                </a:lnTo>
                <a:close/>
              </a:path>
              <a:path fill="lighten" w="4304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48" h="21600">
                <a:moveTo>
                  <a:pt x="14517" y="10800"/>
                </a:moveTo>
                <a:lnTo>
                  <a:pt x="28530" y="3794"/>
                </a:lnTo>
                <a:lnTo>
                  <a:pt x="28530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"/>
          <p:cNvSpPr/>
          <p:nvPr/>
        </p:nvSpPr>
        <p:spPr>
          <a:xfrm>
            <a:off x="533520" y="609480"/>
            <a:ext cx="4730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12" name=""/>
          <p:cNvGrpSpPr/>
          <p:nvPr/>
        </p:nvGrpSpPr>
        <p:grpSpPr>
          <a:xfrm>
            <a:off x="914400" y="3352680"/>
            <a:ext cx="6858000" cy="2211480"/>
            <a:chOff x="914400" y="3352680"/>
            <a:chExt cx="6858000" cy="2211480"/>
          </a:xfrm>
        </p:grpSpPr>
        <p:sp>
          <p:nvSpPr>
            <p:cNvPr id="213" name=""/>
            <p:cNvSpPr/>
            <p:nvPr/>
          </p:nvSpPr>
          <p:spPr>
            <a:xfrm>
              <a:off x="4086360" y="4403880"/>
              <a:ext cx="1676160" cy="39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pyruvate-formate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lyase-activating enzyme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4800600" y="4105440"/>
              <a:ext cx="137160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methyltransferase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1295280" y="3352680"/>
              <a:ext cx="41940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1714680" y="335268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2133720" y="335268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2552760" y="335268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2971800" y="335268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3390840" y="335268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3809880" y="3352680"/>
              <a:ext cx="41940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4229280" y="335268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648320" y="335268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5067360" y="335268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5486400" y="335268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5905440" y="335268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6324480" y="3352680"/>
              <a:ext cx="41940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6743880" y="335268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3343320" y="33526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mcrC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3733920" y="335268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914400" y="4098960"/>
              <a:ext cx="12952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conserved hypothetical protei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1219320" y="335268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1647720" y="33526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2057400" y="33526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2486160" y="335268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2895480" y="33526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4191120" y="335268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4572000" y="33526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5010120" y="33526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5410080" y="33526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5838840" y="33526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6248520" y="335268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6686640" y="335268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1219320" y="5022720"/>
              <a:ext cx="16761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predicted protease of the collagenase family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245" name=""/>
            <p:cNvCxnSpPr>
              <a:stCxn id="244" idx="0"/>
              <a:endCxn id="234" idx="2"/>
            </p:cNvCxnSpPr>
            <p:nvPr/>
          </p:nvCxnSpPr>
          <p:spPr>
            <a:xfrm flipV="1">
              <a:off x="2057040" y="3596760"/>
              <a:ext cx="267120" cy="1426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246" name=""/>
            <p:cNvCxnSpPr>
              <a:stCxn id="231" idx="0"/>
              <a:endCxn id="232" idx="2"/>
            </p:cNvCxnSpPr>
            <p:nvPr/>
          </p:nvCxnSpPr>
          <p:spPr>
            <a:xfrm flipH="1" flipV="1">
              <a:off x="1485360" y="3596760"/>
              <a:ext cx="76680" cy="5025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247" name=""/>
            <p:cNvCxnSpPr>
              <a:stCxn id="248" idx="0"/>
              <a:endCxn id="235" idx="2"/>
            </p:cNvCxnSpPr>
            <p:nvPr/>
          </p:nvCxnSpPr>
          <p:spPr>
            <a:xfrm flipH="1" flipV="1">
              <a:off x="2752200" y="3596760"/>
              <a:ext cx="115200" cy="5025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249" name=""/>
            <p:cNvCxnSpPr>
              <a:stCxn id="248" idx="0"/>
              <a:endCxn id="236" idx="2"/>
            </p:cNvCxnSpPr>
            <p:nvPr/>
          </p:nvCxnSpPr>
          <p:spPr>
            <a:xfrm flipV="1">
              <a:off x="2867040" y="3596760"/>
              <a:ext cx="295560" cy="5025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250" name=""/>
            <p:cNvCxnSpPr>
              <a:stCxn id="251" idx="0"/>
              <a:endCxn id="230" idx="2"/>
            </p:cNvCxnSpPr>
            <p:nvPr/>
          </p:nvCxnSpPr>
          <p:spPr>
            <a:xfrm flipH="1" flipV="1">
              <a:off x="3999960" y="3596400"/>
              <a:ext cx="76680" cy="499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252" name=""/>
            <p:cNvSpPr/>
            <p:nvPr/>
          </p:nvSpPr>
          <p:spPr>
            <a:xfrm>
              <a:off x="3200400" y="5013360"/>
              <a:ext cx="167652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oxygen-sensitive ribonucleoside-triphosphate reductase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253" name=""/>
            <p:cNvCxnSpPr>
              <a:stCxn id="252" idx="0"/>
              <a:endCxn id="237" idx="2"/>
            </p:cNvCxnSpPr>
            <p:nvPr/>
          </p:nvCxnSpPr>
          <p:spPr>
            <a:xfrm flipV="1">
              <a:off x="4038120" y="3596760"/>
              <a:ext cx="420120" cy="14169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254" name=""/>
            <p:cNvCxnSpPr>
              <a:stCxn id="231" idx="0"/>
              <a:endCxn id="233" idx="2"/>
            </p:cNvCxnSpPr>
            <p:nvPr/>
          </p:nvCxnSpPr>
          <p:spPr>
            <a:xfrm flipV="1">
              <a:off x="1561680" y="3596760"/>
              <a:ext cx="353160" cy="5025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248" name=""/>
            <p:cNvSpPr/>
            <p:nvPr/>
          </p:nvSpPr>
          <p:spPr>
            <a:xfrm>
              <a:off x="2104920" y="4098960"/>
              <a:ext cx="152424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methyl coenzyme M reductase system component A2 (atw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255" name=""/>
            <p:cNvCxnSpPr>
              <a:stCxn id="213" idx="0"/>
              <a:endCxn id="238" idx="2"/>
            </p:cNvCxnSpPr>
            <p:nvPr/>
          </p:nvCxnSpPr>
          <p:spPr>
            <a:xfrm flipH="1" flipV="1">
              <a:off x="4838400" y="3596400"/>
              <a:ext cx="86400" cy="8074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256" name=""/>
            <p:cNvCxnSpPr>
              <a:stCxn id="214" idx="0"/>
              <a:endCxn id="239" idx="2"/>
            </p:cNvCxnSpPr>
            <p:nvPr/>
          </p:nvCxnSpPr>
          <p:spPr>
            <a:xfrm flipH="1" flipV="1">
              <a:off x="5276520" y="3596760"/>
              <a:ext cx="210240" cy="5090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251" name=""/>
            <p:cNvSpPr/>
            <p:nvPr/>
          </p:nvSpPr>
          <p:spPr>
            <a:xfrm>
              <a:off x="3429000" y="4095720"/>
              <a:ext cx="1295280" cy="39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conserved hypothetical protei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6400800" y="4114800"/>
              <a:ext cx="1371600" cy="39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conserved hypothetical protei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258" name=""/>
            <p:cNvCxnSpPr>
              <a:stCxn id="257" idx="0"/>
              <a:endCxn id="240" idx="2"/>
            </p:cNvCxnSpPr>
            <p:nvPr/>
          </p:nvCxnSpPr>
          <p:spPr>
            <a:xfrm flipH="1" flipV="1">
              <a:off x="5676480" y="3596760"/>
              <a:ext cx="1410480" cy="518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259" name=""/>
            <p:cNvSpPr/>
            <p:nvPr/>
          </p:nvSpPr>
          <p:spPr>
            <a:xfrm>
              <a:off x="5638680" y="5089680"/>
              <a:ext cx="1371600" cy="39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dGTP triphosphohydrolase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260" name=""/>
            <p:cNvCxnSpPr>
              <a:stCxn id="257" idx="0"/>
              <a:endCxn id="242" idx="2"/>
            </p:cNvCxnSpPr>
            <p:nvPr/>
          </p:nvCxnSpPr>
          <p:spPr>
            <a:xfrm flipH="1" flipV="1">
              <a:off x="6514560" y="3596760"/>
              <a:ext cx="572040" cy="518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261" name=""/>
            <p:cNvCxnSpPr>
              <a:stCxn id="257" idx="0"/>
              <a:endCxn id="243" idx="2"/>
            </p:cNvCxnSpPr>
            <p:nvPr/>
          </p:nvCxnSpPr>
          <p:spPr>
            <a:xfrm flipH="1" flipV="1">
              <a:off x="6953400" y="3596760"/>
              <a:ext cx="133560" cy="518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262" name=""/>
            <p:cNvCxnSpPr>
              <a:stCxn id="259" idx="0"/>
              <a:endCxn id="241" idx="2"/>
            </p:cNvCxnSpPr>
            <p:nvPr/>
          </p:nvCxnSpPr>
          <p:spPr>
            <a:xfrm flipH="1" flipV="1">
              <a:off x="6105240" y="3596760"/>
              <a:ext cx="219600" cy="14932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</p:grp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B472FA8-E9BA-499F-BFD0-FF5E063277DC}" type="slidenum">
              <a:t>29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Selection of Key Genes for</a:t>
            </a:r>
            <a:br>
              <a:rPr sz="2800"/>
            </a:b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methanogenesis and AOM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250920" y="1971360"/>
            <a:ext cx="8686800" cy="426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The red underlined genes on the previous slide were used for the analysis.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The mcr gene is known to be a strongly conserved gene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In order to show this, two different sequences for subunit A (mcrA) were tested, which produced the same Blast results and therefore also the same patterns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1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mcrA-AAC4340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mcrA-AAM3093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For all other subunits only one sequence was analysed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All Blast searches were carried out with threshold 1E-5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>
            <a:hlinkClick r:id="rId3" action="ppaction://hlinksldjump"/>
          </p:cNvPr>
          <p:cNvSpPr/>
          <p:nvPr/>
        </p:nvSpPr>
        <p:spPr>
          <a:xfrm>
            <a:off x="3492360" y="449892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>
            <a:hlinkClick r:id="rId4" action="ppaction://hlinksldjump"/>
          </p:cNvPr>
          <p:cNvSpPr/>
          <p:nvPr/>
        </p:nvSpPr>
        <p:spPr>
          <a:xfrm>
            <a:off x="3492360" y="484992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387F035-715A-4185-9044-D3AADA26A136}" type="slidenum">
              <a:t>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PlaceHolder 1"/>
          <p:cNvSpPr>
            <a:spLocks noGrp="1"/>
          </p:cNvSpPr>
          <p:nvPr>
            <p:ph/>
          </p:nvPr>
        </p:nvSpPr>
        <p:spPr>
          <a:xfrm>
            <a:off x="228240" y="1143000"/>
            <a:ext cx="8915400" cy="5410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Samples: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1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3044 (BX950229), 3035 (L77117), 3037 (AE009439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(3040 - AE010299, 3210 - AY714865, 3268 - AY327049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2000" spc="-1" strike="noStrike">
                <a:solidFill>
                  <a:srgbClr val="000000"/>
                </a:solidFill>
                <a:latin typeface="Arial"/>
              </a:rPr>
              <a:t>Methanopyrus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i="1" lang="de-DE" sz="2000" spc="-1" strike="noStrike">
                <a:solidFill>
                  <a:srgbClr val="000000"/>
                </a:solidFill>
                <a:latin typeface="Arial"/>
              </a:rPr>
              <a:t>Methanocaldococcus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i="1" lang="de-DE" sz="2000" spc="-1" strike="noStrike">
                <a:solidFill>
                  <a:srgbClr val="000000"/>
                </a:solidFill>
                <a:latin typeface="Arial"/>
              </a:rPr>
              <a:t>Methanococcus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i="1" lang="de-DE" sz="2000" spc="-1" strike="noStrike">
                <a:solidFill>
                  <a:srgbClr val="000000"/>
                </a:solidFill>
                <a:latin typeface="Arial"/>
              </a:rPr>
              <a:t>Methanosacrina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,metagenome Eel River Bas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3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Sediment, geothermal, water depth levels 2; 14; 26-27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Longest extension with mismatches: </a:t>
            </a:r>
            <a:r>
              <a:rPr b="0" lang="de-DE" sz="2400" spc="-1" strike="noStrike">
                <a:solidFill>
                  <a:srgbClr val="000000"/>
                </a:solidFill>
                <a:latin typeface="Symbol"/>
                <a:ea typeface="Symbol"/>
              </a:rPr>
              <a:t></a:t>
            </a: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 length 1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PlaceHolder 2"/>
          <p:cNvSpPr>
            <a:spLocks noGrp="1"/>
          </p:cNvSpPr>
          <p:nvPr>
            <p:ph type="title"/>
          </p:nvPr>
        </p:nvSpPr>
        <p:spPr>
          <a:xfrm>
            <a:off x="685800" y="30456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mcrB/D/C/G/A</a:t>
            </a: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 – 11/5apattern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>
            <a:hlinkClick r:id="rId4" action="ppaction://hlinksldjump"/>
          </p:cNvPr>
          <p:cNvSpPr/>
          <p:nvPr/>
        </p:nvSpPr>
        <p:spPr>
          <a:xfrm>
            <a:off x="4229280" y="838080"/>
            <a:ext cx="304560" cy="15264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48" h="21600">
                <a:moveTo>
                  <a:pt x="0" y="0"/>
                </a:moveTo>
                <a:lnTo>
                  <a:pt x="43048" y="0"/>
                </a:lnTo>
                <a:lnTo>
                  <a:pt x="43048" y="21600"/>
                </a:lnTo>
                <a:lnTo>
                  <a:pt x="0" y="21600"/>
                </a:lnTo>
                <a:close/>
              </a:path>
              <a:path fill="lightenLess" w="43048" h="21600">
                <a:moveTo>
                  <a:pt x="0" y="0"/>
                </a:moveTo>
                <a:lnTo>
                  <a:pt x="43048" y="0"/>
                </a:lnTo>
                <a:lnTo>
                  <a:pt x="41648" y="1400"/>
                </a:lnTo>
                <a:lnTo>
                  <a:pt x="1400" y="1400"/>
                </a:lnTo>
                <a:close/>
              </a:path>
              <a:path fill="darken" w="43048" h="21600">
                <a:moveTo>
                  <a:pt x="43048" y="0"/>
                </a:moveTo>
                <a:lnTo>
                  <a:pt x="43048" y="21600"/>
                </a:lnTo>
                <a:lnTo>
                  <a:pt x="41648" y="20200"/>
                </a:lnTo>
                <a:lnTo>
                  <a:pt x="41648" y="1400"/>
                </a:lnTo>
                <a:close/>
              </a:path>
              <a:path fill="darkenLess" w="43048" h="21600">
                <a:moveTo>
                  <a:pt x="4304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48" y="20200"/>
                </a:lnTo>
                <a:close/>
              </a:path>
              <a:path fill="lighten" w="4304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48" h="21600">
                <a:moveTo>
                  <a:pt x="14517" y="10800"/>
                </a:moveTo>
                <a:lnTo>
                  <a:pt x="28530" y="3794"/>
                </a:lnTo>
                <a:lnTo>
                  <a:pt x="28530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6" name="">
            <a:hlinkClick r:id="rId5" action="ppaction://hlinksldjump"/>
          </p:cNvPr>
          <p:cNvSpPr/>
          <p:nvPr/>
        </p:nvSpPr>
        <p:spPr>
          <a:xfrm>
            <a:off x="2778120" y="101592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10800"/>
                </a:moveTo>
                <a:lnTo>
                  <a:pt x="28556" y="3794"/>
                </a:lnTo>
                <a:lnTo>
                  <a:pt x="2855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7" name="">
            <a:hlinkClick r:id="rId6" action="ppaction://hlinksldjump"/>
          </p:cNvPr>
          <p:cNvSpPr/>
          <p:nvPr/>
        </p:nvSpPr>
        <p:spPr>
          <a:xfrm>
            <a:off x="3505320" y="838080"/>
            <a:ext cx="304560" cy="15264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48" h="21600">
                <a:moveTo>
                  <a:pt x="0" y="0"/>
                </a:moveTo>
                <a:lnTo>
                  <a:pt x="43048" y="0"/>
                </a:lnTo>
                <a:lnTo>
                  <a:pt x="43048" y="21600"/>
                </a:lnTo>
                <a:lnTo>
                  <a:pt x="0" y="21600"/>
                </a:lnTo>
                <a:close/>
              </a:path>
              <a:path fill="lightenLess" w="43048" h="21600">
                <a:moveTo>
                  <a:pt x="0" y="0"/>
                </a:moveTo>
                <a:lnTo>
                  <a:pt x="43048" y="0"/>
                </a:lnTo>
                <a:lnTo>
                  <a:pt x="41648" y="1400"/>
                </a:lnTo>
                <a:lnTo>
                  <a:pt x="1400" y="1400"/>
                </a:lnTo>
                <a:close/>
              </a:path>
              <a:path fill="darken" w="43048" h="21600">
                <a:moveTo>
                  <a:pt x="43048" y="0"/>
                </a:moveTo>
                <a:lnTo>
                  <a:pt x="43048" y="21600"/>
                </a:lnTo>
                <a:lnTo>
                  <a:pt x="41648" y="20200"/>
                </a:lnTo>
                <a:lnTo>
                  <a:pt x="41648" y="1400"/>
                </a:lnTo>
                <a:close/>
              </a:path>
              <a:path fill="darkenLess" w="43048" h="21600">
                <a:moveTo>
                  <a:pt x="4304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48" y="20200"/>
                </a:lnTo>
                <a:close/>
              </a:path>
              <a:path fill="lighten" w="4304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48" h="21600">
                <a:moveTo>
                  <a:pt x="14517" y="10800"/>
                </a:moveTo>
                <a:lnTo>
                  <a:pt x="28530" y="3794"/>
                </a:lnTo>
                <a:lnTo>
                  <a:pt x="28530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8" name=""/>
          <p:cNvSpPr/>
          <p:nvPr/>
        </p:nvSpPr>
        <p:spPr>
          <a:xfrm>
            <a:off x="533520" y="609480"/>
            <a:ext cx="4730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9" name="">
            <a:hlinkClick r:id="rId7" action="ppaction://hlinksldjump"/>
          </p:cNvPr>
          <p:cNvSpPr/>
          <p:nvPr/>
        </p:nvSpPr>
        <p:spPr>
          <a:xfrm>
            <a:off x="4229280" y="1009800"/>
            <a:ext cx="304560" cy="15228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149" h="21600">
                <a:moveTo>
                  <a:pt x="0" y="0"/>
                </a:moveTo>
                <a:lnTo>
                  <a:pt x="43149" y="0"/>
                </a:lnTo>
                <a:lnTo>
                  <a:pt x="43149" y="21600"/>
                </a:lnTo>
                <a:lnTo>
                  <a:pt x="0" y="21600"/>
                </a:lnTo>
                <a:close/>
              </a:path>
              <a:path fill="lightenLess" w="43149" h="21600">
                <a:moveTo>
                  <a:pt x="0" y="0"/>
                </a:moveTo>
                <a:lnTo>
                  <a:pt x="43149" y="0"/>
                </a:lnTo>
                <a:lnTo>
                  <a:pt x="41749" y="1400"/>
                </a:lnTo>
                <a:lnTo>
                  <a:pt x="1400" y="1400"/>
                </a:lnTo>
                <a:close/>
              </a:path>
              <a:path fill="darken" w="43149" h="21600">
                <a:moveTo>
                  <a:pt x="43149" y="0"/>
                </a:moveTo>
                <a:lnTo>
                  <a:pt x="43149" y="21600"/>
                </a:lnTo>
                <a:lnTo>
                  <a:pt x="41749" y="20200"/>
                </a:lnTo>
                <a:lnTo>
                  <a:pt x="41749" y="1400"/>
                </a:lnTo>
                <a:close/>
              </a:path>
              <a:path fill="darkenLess" w="43149" h="21600">
                <a:moveTo>
                  <a:pt x="43149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749" y="20200"/>
                </a:lnTo>
                <a:close/>
              </a:path>
              <a:path fill="lighten" w="43149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149" h="21600">
                <a:moveTo>
                  <a:pt x="14568" y="10800"/>
                </a:moveTo>
                <a:lnTo>
                  <a:pt x="28581" y="3794"/>
                </a:lnTo>
                <a:lnTo>
                  <a:pt x="28581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0" name="">
            <a:hlinkClick r:id="rId8" action="ppaction://hlinksldjump"/>
          </p:cNvPr>
          <p:cNvSpPr/>
          <p:nvPr/>
        </p:nvSpPr>
        <p:spPr>
          <a:xfrm>
            <a:off x="4572000" y="100980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10800"/>
                </a:moveTo>
                <a:lnTo>
                  <a:pt x="28606" y="3794"/>
                </a:lnTo>
                <a:lnTo>
                  <a:pt x="2860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1" name="">
            <a:hlinkClick r:id="rId9" action="ppaction://hlinksldjump"/>
          </p:cNvPr>
          <p:cNvSpPr/>
          <p:nvPr/>
        </p:nvSpPr>
        <p:spPr>
          <a:xfrm>
            <a:off x="4572000" y="83808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10800"/>
                </a:moveTo>
                <a:lnTo>
                  <a:pt x="28556" y="3794"/>
                </a:lnTo>
                <a:lnTo>
                  <a:pt x="2855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2" name="">
            <a:hlinkClick r:id="rId10" action="ppaction://hlinksldjump"/>
          </p:cNvPr>
          <p:cNvSpPr/>
          <p:nvPr/>
        </p:nvSpPr>
        <p:spPr>
          <a:xfrm>
            <a:off x="3137040" y="838080"/>
            <a:ext cx="304560" cy="15264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48" h="21600">
                <a:moveTo>
                  <a:pt x="0" y="0"/>
                </a:moveTo>
                <a:lnTo>
                  <a:pt x="43048" y="0"/>
                </a:lnTo>
                <a:lnTo>
                  <a:pt x="43048" y="21600"/>
                </a:lnTo>
                <a:lnTo>
                  <a:pt x="0" y="21600"/>
                </a:lnTo>
                <a:close/>
              </a:path>
              <a:path fill="lightenLess" w="43048" h="21600">
                <a:moveTo>
                  <a:pt x="0" y="0"/>
                </a:moveTo>
                <a:lnTo>
                  <a:pt x="43048" y="0"/>
                </a:lnTo>
                <a:lnTo>
                  <a:pt x="41648" y="1400"/>
                </a:lnTo>
                <a:lnTo>
                  <a:pt x="1400" y="1400"/>
                </a:lnTo>
                <a:close/>
              </a:path>
              <a:path fill="darken" w="43048" h="21600">
                <a:moveTo>
                  <a:pt x="43048" y="0"/>
                </a:moveTo>
                <a:lnTo>
                  <a:pt x="43048" y="21600"/>
                </a:lnTo>
                <a:lnTo>
                  <a:pt x="41648" y="20200"/>
                </a:lnTo>
                <a:lnTo>
                  <a:pt x="41648" y="1400"/>
                </a:lnTo>
                <a:close/>
              </a:path>
              <a:path fill="darkenLess" w="43048" h="21600">
                <a:moveTo>
                  <a:pt x="4304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48" y="20200"/>
                </a:lnTo>
                <a:close/>
              </a:path>
              <a:path fill="lighten" w="4304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48" h="21600">
                <a:moveTo>
                  <a:pt x="14517" y="10800"/>
                </a:moveTo>
                <a:lnTo>
                  <a:pt x="28530" y="3794"/>
                </a:lnTo>
                <a:lnTo>
                  <a:pt x="28530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3" name="">
            <a:hlinkClick r:id="rId11" action="ppaction://hlinksldjump"/>
          </p:cNvPr>
          <p:cNvSpPr/>
          <p:nvPr/>
        </p:nvSpPr>
        <p:spPr>
          <a:xfrm>
            <a:off x="3873600" y="838080"/>
            <a:ext cx="304560" cy="15264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48" h="21600">
                <a:moveTo>
                  <a:pt x="0" y="0"/>
                </a:moveTo>
                <a:lnTo>
                  <a:pt x="43048" y="0"/>
                </a:lnTo>
                <a:lnTo>
                  <a:pt x="43048" y="21600"/>
                </a:lnTo>
                <a:lnTo>
                  <a:pt x="0" y="21600"/>
                </a:lnTo>
                <a:close/>
              </a:path>
              <a:path fill="lightenLess" w="43048" h="21600">
                <a:moveTo>
                  <a:pt x="0" y="0"/>
                </a:moveTo>
                <a:lnTo>
                  <a:pt x="43048" y="0"/>
                </a:lnTo>
                <a:lnTo>
                  <a:pt x="41648" y="1400"/>
                </a:lnTo>
                <a:lnTo>
                  <a:pt x="1400" y="1400"/>
                </a:lnTo>
                <a:close/>
              </a:path>
              <a:path fill="darken" w="43048" h="21600">
                <a:moveTo>
                  <a:pt x="43048" y="0"/>
                </a:moveTo>
                <a:lnTo>
                  <a:pt x="43048" y="21600"/>
                </a:lnTo>
                <a:lnTo>
                  <a:pt x="41648" y="20200"/>
                </a:lnTo>
                <a:lnTo>
                  <a:pt x="41648" y="1400"/>
                </a:lnTo>
                <a:close/>
              </a:path>
              <a:path fill="darkenLess" w="43048" h="21600">
                <a:moveTo>
                  <a:pt x="4304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48" y="20200"/>
                </a:lnTo>
                <a:close/>
              </a:path>
              <a:path fill="lighten" w="4304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48" h="21600">
                <a:moveTo>
                  <a:pt x="14517" y="10800"/>
                </a:moveTo>
                <a:lnTo>
                  <a:pt x="28530" y="3794"/>
                </a:lnTo>
                <a:lnTo>
                  <a:pt x="28530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74" name=""/>
          <p:cNvGrpSpPr/>
          <p:nvPr/>
        </p:nvGrpSpPr>
        <p:grpSpPr>
          <a:xfrm>
            <a:off x="1219320" y="4222800"/>
            <a:ext cx="6705000" cy="1754280"/>
            <a:chOff x="1219320" y="4222800"/>
            <a:chExt cx="6705000" cy="1754280"/>
          </a:xfrm>
        </p:grpSpPr>
        <p:sp>
          <p:nvSpPr>
            <p:cNvPr id="275" name=""/>
            <p:cNvSpPr/>
            <p:nvPr/>
          </p:nvSpPr>
          <p:spPr>
            <a:xfrm>
              <a:off x="5867280" y="5425920"/>
              <a:ext cx="121860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subunit B (mtrB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1676160" y="4222800"/>
              <a:ext cx="41868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2095200" y="4222800"/>
              <a:ext cx="41868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2514240" y="422280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2933640" y="4222800"/>
              <a:ext cx="41868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4190760" y="4222800"/>
              <a:ext cx="41868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4609800" y="4222800"/>
              <a:ext cx="41868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5028840" y="422280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5448240" y="4222800"/>
              <a:ext cx="41868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5867280" y="4222800"/>
              <a:ext cx="41868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2047680" y="422280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mcr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4114440" y="422280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1599840" y="422280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2457360" y="4222800"/>
              <a:ext cx="53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mcrD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2895480" y="4222800"/>
              <a:ext cx="53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mcrC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4571640" y="422280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4952880" y="4222800"/>
              <a:ext cx="53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5391000" y="4222800"/>
              <a:ext cx="53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5790960" y="422280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2819160" y="4984560"/>
              <a:ext cx="2209320" cy="703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N5-methyl-tetrahydromethanopterin:coenzyme M methyltransferase,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subunit E (mtrE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3352680" y="4222800"/>
              <a:ext cx="41868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3771720" y="4222800"/>
              <a:ext cx="41868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3327120" y="422280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mcr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3733560" y="422280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mcr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1219320" y="4984560"/>
              <a:ext cx="1294920" cy="39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Fe-S oxidoreductase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300" name=""/>
            <p:cNvCxnSpPr>
              <a:stCxn id="299" idx="0"/>
              <a:endCxn id="287" idx="2"/>
            </p:cNvCxnSpPr>
            <p:nvPr/>
          </p:nvCxnSpPr>
          <p:spPr>
            <a:xfrm flipV="1">
              <a:off x="1866240" y="4466520"/>
              <a:ext cx="1080" cy="5180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301" name=""/>
            <p:cNvCxnSpPr>
              <a:stCxn id="294" idx="0"/>
              <a:endCxn id="286" idx="2"/>
            </p:cNvCxnSpPr>
            <p:nvPr/>
          </p:nvCxnSpPr>
          <p:spPr>
            <a:xfrm flipV="1">
              <a:off x="3923640" y="4466520"/>
              <a:ext cx="457560" cy="5180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302" name=""/>
            <p:cNvSpPr/>
            <p:nvPr/>
          </p:nvSpPr>
          <p:spPr>
            <a:xfrm>
              <a:off x="4647960" y="5435640"/>
              <a:ext cx="12189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subunit D (mtrD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303" name=""/>
            <p:cNvCxnSpPr>
              <a:stCxn id="302" idx="0"/>
              <a:endCxn id="290" idx="2"/>
            </p:cNvCxnSpPr>
            <p:nvPr/>
          </p:nvCxnSpPr>
          <p:spPr>
            <a:xfrm flipH="1" flipV="1">
              <a:off x="4837680" y="4466880"/>
              <a:ext cx="419400" cy="9691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304" name=""/>
            <p:cNvSpPr/>
            <p:nvPr/>
          </p:nvSpPr>
          <p:spPr>
            <a:xfrm>
              <a:off x="5333760" y="5730840"/>
              <a:ext cx="12189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subunit C (mtrC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305" name=""/>
            <p:cNvCxnSpPr>
              <a:stCxn id="304" idx="0"/>
              <a:endCxn id="291" idx="2"/>
            </p:cNvCxnSpPr>
            <p:nvPr/>
          </p:nvCxnSpPr>
          <p:spPr>
            <a:xfrm flipH="1" flipV="1">
              <a:off x="5218920" y="4466880"/>
              <a:ext cx="723960" cy="1264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306" name=""/>
            <p:cNvCxnSpPr>
              <a:stCxn id="275" idx="0"/>
              <a:endCxn id="292" idx="2"/>
            </p:cNvCxnSpPr>
            <p:nvPr/>
          </p:nvCxnSpPr>
          <p:spPr>
            <a:xfrm flipH="1" flipV="1">
              <a:off x="5657400" y="4466520"/>
              <a:ext cx="819360" cy="959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307" name=""/>
            <p:cNvSpPr/>
            <p:nvPr/>
          </p:nvSpPr>
          <p:spPr>
            <a:xfrm>
              <a:off x="6705360" y="5730840"/>
              <a:ext cx="12189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subunit A (mtrA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308" name=""/>
            <p:cNvCxnSpPr>
              <a:stCxn id="307" idx="0"/>
              <a:endCxn id="293" idx="2"/>
            </p:cNvCxnSpPr>
            <p:nvPr/>
          </p:nvCxnSpPr>
          <p:spPr>
            <a:xfrm flipH="1" flipV="1">
              <a:off x="6057360" y="4466880"/>
              <a:ext cx="1257120" cy="1264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</p:grpSp>
      <p:sp>
        <p:nvSpPr>
          <p:cNvPr id="309" name="">
            <a:hlinkClick r:id="rId12" action="ppaction://hlinksldjump"/>
          </p:cNvPr>
          <p:cNvSpPr/>
          <p:nvPr/>
        </p:nvSpPr>
        <p:spPr>
          <a:xfrm>
            <a:off x="3132000" y="101448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10800"/>
                </a:moveTo>
                <a:lnTo>
                  <a:pt x="28606" y="3794"/>
                </a:lnTo>
                <a:lnTo>
                  <a:pt x="2860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0" name="">
            <a:hlinkClick r:id="rId13" action="ppaction://hlinksldjump"/>
          </p:cNvPr>
          <p:cNvSpPr/>
          <p:nvPr/>
        </p:nvSpPr>
        <p:spPr>
          <a:xfrm>
            <a:off x="3511440" y="102564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10800"/>
                </a:moveTo>
                <a:lnTo>
                  <a:pt x="28606" y="3794"/>
                </a:lnTo>
                <a:lnTo>
                  <a:pt x="2860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1" name="">
            <a:hlinkClick r:id="rId14" action="ppaction://hlinksldjump"/>
          </p:cNvPr>
          <p:cNvSpPr/>
          <p:nvPr/>
        </p:nvSpPr>
        <p:spPr>
          <a:xfrm>
            <a:off x="2771640" y="83664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10800"/>
                </a:moveTo>
                <a:lnTo>
                  <a:pt x="28606" y="3794"/>
                </a:lnTo>
                <a:lnTo>
                  <a:pt x="2860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2" name="">
            <a:hlinkClick r:id="rId15" action="ppaction://hlinksldjump"/>
          </p:cNvPr>
          <p:cNvSpPr/>
          <p:nvPr/>
        </p:nvSpPr>
        <p:spPr>
          <a:xfrm>
            <a:off x="3870360" y="102564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10800"/>
                </a:moveTo>
                <a:lnTo>
                  <a:pt x="28606" y="3794"/>
                </a:lnTo>
                <a:lnTo>
                  <a:pt x="2860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B2E5E37-46C7-4B0C-B1A9-EECB16A7BF8F}" type="slidenum">
              <a:t>30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685800" y="30456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mcrC/B/G/A</a:t>
            </a: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 - 5bpattern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>
            <a:hlinkClick r:id="rId1" action="ppaction://hlinksldjump"/>
          </p:cNvPr>
          <p:cNvSpPr/>
          <p:nvPr/>
        </p:nvSpPr>
        <p:spPr>
          <a:xfrm>
            <a:off x="4295880" y="838080"/>
            <a:ext cx="304560" cy="15264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48" h="21600">
                <a:moveTo>
                  <a:pt x="0" y="0"/>
                </a:moveTo>
                <a:lnTo>
                  <a:pt x="43048" y="0"/>
                </a:lnTo>
                <a:lnTo>
                  <a:pt x="43048" y="21600"/>
                </a:lnTo>
                <a:lnTo>
                  <a:pt x="0" y="21600"/>
                </a:lnTo>
                <a:close/>
              </a:path>
              <a:path fill="lightenLess" w="43048" h="21600">
                <a:moveTo>
                  <a:pt x="0" y="0"/>
                </a:moveTo>
                <a:lnTo>
                  <a:pt x="43048" y="0"/>
                </a:lnTo>
                <a:lnTo>
                  <a:pt x="41648" y="1400"/>
                </a:lnTo>
                <a:lnTo>
                  <a:pt x="1400" y="1400"/>
                </a:lnTo>
                <a:close/>
              </a:path>
              <a:path fill="darken" w="43048" h="21600">
                <a:moveTo>
                  <a:pt x="43048" y="0"/>
                </a:moveTo>
                <a:lnTo>
                  <a:pt x="43048" y="21600"/>
                </a:lnTo>
                <a:lnTo>
                  <a:pt x="41648" y="20200"/>
                </a:lnTo>
                <a:lnTo>
                  <a:pt x="41648" y="1400"/>
                </a:lnTo>
                <a:close/>
              </a:path>
              <a:path fill="darkenLess" w="43048" h="21600">
                <a:moveTo>
                  <a:pt x="4304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48" y="20200"/>
                </a:lnTo>
                <a:close/>
              </a:path>
              <a:path fill="lighten" w="4304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48" h="21600">
                <a:moveTo>
                  <a:pt x="14517" y="10800"/>
                </a:moveTo>
                <a:lnTo>
                  <a:pt x="28530" y="3794"/>
                </a:lnTo>
                <a:lnTo>
                  <a:pt x="28530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5" name=""/>
          <p:cNvSpPr/>
          <p:nvPr/>
        </p:nvSpPr>
        <p:spPr>
          <a:xfrm>
            <a:off x="3543480" y="838080"/>
            <a:ext cx="304560" cy="15264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48" h="21600">
                <a:moveTo>
                  <a:pt x="0" y="0"/>
                </a:moveTo>
                <a:lnTo>
                  <a:pt x="43048" y="0"/>
                </a:lnTo>
                <a:lnTo>
                  <a:pt x="43048" y="21600"/>
                </a:lnTo>
                <a:lnTo>
                  <a:pt x="0" y="21600"/>
                </a:lnTo>
                <a:close/>
              </a:path>
              <a:path fill="lightenLess" w="43048" h="21600">
                <a:moveTo>
                  <a:pt x="0" y="0"/>
                </a:moveTo>
                <a:lnTo>
                  <a:pt x="43048" y="0"/>
                </a:lnTo>
                <a:lnTo>
                  <a:pt x="41648" y="1400"/>
                </a:lnTo>
                <a:lnTo>
                  <a:pt x="1400" y="1400"/>
                </a:lnTo>
                <a:close/>
              </a:path>
              <a:path fill="darken" w="43048" h="21600">
                <a:moveTo>
                  <a:pt x="43048" y="0"/>
                </a:moveTo>
                <a:lnTo>
                  <a:pt x="43048" y="21600"/>
                </a:lnTo>
                <a:lnTo>
                  <a:pt x="41648" y="20200"/>
                </a:lnTo>
                <a:lnTo>
                  <a:pt x="41648" y="1400"/>
                </a:lnTo>
                <a:close/>
              </a:path>
              <a:path fill="darkenLess" w="43048" h="21600">
                <a:moveTo>
                  <a:pt x="4304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48" y="20200"/>
                </a:lnTo>
                <a:close/>
              </a:path>
              <a:path fill="lighten" w="4304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48" h="21600">
                <a:moveTo>
                  <a:pt x="14517" y="10800"/>
                </a:moveTo>
                <a:lnTo>
                  <a:pt x="28530" y="3794"/>
                </a:lnTo>
                <a:lnTo>
                  <a:pt x="28530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6" name=""/>
          <p:cNvSpPr/>
          <p:nvPr/>
        </p:nvSpPr>
        <p:spPr>
          <a:xfrm>
            <a:off x="533520" y="609480"/>
            <a:ext cx="4730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7" name="">
            <a:hlinkClick r:id="rId2" action="ppaction://hlinksldjump"/>
          </p:cNvPr>
          <p:cNvSpPr/>
          <p:nvPr/>
        </p:nvSpPr>
        <p:spPr>
          <a:xfrm>
            <a:off x="4292640" y="102888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10800"/>
                </a:moveTo>
                <a:lnTo>
                  <a:pt x="28606" y="3794"/>
                </a:lnTo>
                <a:lnTo>
                  <a:pt x="2860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8" name=""/>
          <p:cNvSpPr/>
          <p:nvPr/>
        </p:nvSpPr>
        <p:spPr>
          <a:xfrm>
            <a:off x="3149640" y="83808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10800"/>
                </a:moveTo>
                <a:lnTo>
                  <a:pt x="28556" y="3794"/>
                </a:lnTo>
                <a:lnTo>
                  <a:pt x="2855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9" name=""/>
          <p:cNvSpPr/>
          <p:nvPr/>
        </p:nvSpPr>
        <p:spPr>
          <a:xfrm>
            <a:off x="3924360" y="83808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10800"/>
                </a:moveTo>
                <a:lnTo>
                  <a:pt x="28556" y="3794"/>
                </a:lnTo>
                <a:lnTo>
                  <a:pt x="2855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0" name=""/>
          <p:cNvSpPr/>
          <p:nvPr/>
        </p:nvSpPr>
        <p:spPr>
          <a:xfrm>
            <a:off x="3429000" y="463860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1" name=""/>
          <p:cNvSpPr/>
          <p:nvPr/>
        </p:nvSpPr>
        <p:spPr>
          <a:xfrm>
            <a:off x="3848040" y="463860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2" name=""/>
          <p:cNvSpPr/>
          <p:nvPr/>
        </p:nvSpPr>
        <p:spPr>
          <a:xfrm>
            <a:off x="4267080" y="4638600"/>
            <a:ext cx="41940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3" name=""/>
          <p:cNvSpPr/>
          <p:nvPr/>
        </p:nvSpPr>
        <p:spPr>
          <a:xfrm>
            <a:off x="4686480" y="463860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4" name=""/>
          <p:cNvSpPr/>
          <p:nvPr/>
        </p:nvSpPr>
        <p:spPr>
          <a:xfrm>
            <a:off x="3800520" y="463860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cr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5" name=""/>
          <p:cNvSpPr/>
          <p:nvPr/>
        </p:nvSpPr>
        <p:spPr>
          <a:xfrm>
            <a:off x="3352680" y="463860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6" name=""/>
          <p:cNvSpPr/>
          <p:nvPr/>
        </p:nvSpPr>
        <p:spPr>
          <a:xfrm>
            <a:off x="4210200" y="463860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7" name=""/>
          <p:cNvSpPr/>
          <p:nvPr/>
        </p:nvSpPr>
        <p:spPr>
          <a:xfrm>
            <a:off x="4610160" y="463860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28" name=""/>
          <p:cNvGrpSpPr/>
          <p:nvPr/>
        </p:nvGrpSpPr>
        <p:grpSpPr>
          <a:xfrm>
            <a:off x="5460840" y="4638600"/>
            <a:ext cx="1397160" cy="246240"/>
            <a:chOff x="5460840" y="4638600"/>
            <a:chExt cx="1397160" cy="246240"/>
          </a:xfrm>
        </p:grpSpPr>
        <p:sp>
          <p:nvSpPr>
            <p:cNvPr id="329" name=""/>
            <p:cNvSpPr/>
            <p:nvPr/>
          </p:nvSpPr>
          <p:spPr>
            <a:xfrm>
              <a:off x="5524200" y="4638600"/>
              <a:ext cx="41940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5943600" y="463860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5460840" y="463860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mcr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5905440" y="463860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mcr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6362640" y="4638600"/>
              <a:ext cx="419040" cy="228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6324480" y="463860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mcr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35" name=""/>
          <p:cNvSpPr/>
          <p:nvPr/>
        </p:nvSpPr>
        <p:spPr>
          <a:xfrm>
            <a:off x="2590920" y="5400720"/>
            <a:ext cx="1447560" cy="55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ethyl coenzyme M reductase component A2 (atw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6" name=""/>
          <p:cNvSpPr/>
          <p:nvPr/>
        </p:nvSpPr>
        <p:spPr>
          <a:xfrm>
            <a:off x="3009960" y="463860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7" name=""/>
          <p:cNvSpPr/>
          <p:nvPr/>
        </p:nvSpPr>
        <p:spPr>
          <a:xfrm>
            <a:off x="2933640" y="463860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338" name=""/>
          <p:cNvCxnSpPr>
            <a:stCxn id="335" idx="0"/>
            <a:endCxn id="337" idx="2"/>
          </p:cNvCxnSpPr>
          <p:nvPr/>
        </p:nvCxnSpPr>
        <p:spPr>
          <a:xfrm flipH="1" flipV="1">
            <a:off x="3200040" y="4882680"/>
            <a:ext cx="11520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39" name=""/>
          <p:cNvCxnSpPr>
            <a:stCxn id="335" idx="0"/>
            <a:endCxn id="325" idx="2"/>
          </p:cNvCxnSpPr>
          <p:nvPr/>
        </p:nvCxnSpPr>
        <p:spPr>
          <a:xfrm flipV="1">
            <a:off x="3314880" y="4882680"/>
            <a:ext cx="30528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40" name=""/>
          <p:cNvSpPr/>
          <p:nvPr/>
        </p:nvSpPr>
        <p:spPr>
          <a:xfrm>
            <a:off x="4008600" y="5413320"/>
            <a:ext cx="12952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hypothetical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341" name=""/>
          <p:cNvCxnSpPr>
            <a:stCxn id="340" idx="0"/>
            <a:endCxn id="326" idx="2"/>
          </p:cNvCxnSpPr>
          <p:nvPr/>
        </p:nvCxnSpPr>
        <p:spPr>
          <a:xfrm flipH="1" flipV="1">
            <a:off x="4475880" y="4882320"/>
            <a:ext cx="180360" cy="5310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42" name=""/>
          <p:cNvCxnSpPr>
            <a:stCxn id="340" idx="0"/>
            <a:endCxn id="327" idx="2"/>
          </p:cNvCxnSpPr>
          <p:nvPr/>
        </p:nvCxnSpPr>
        <p:spPr>
          <a:xfrm flipV="1">
            <a:off x="4655880" y="4882320"/>
            <a:ext cx="221400" cy="5310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43" name=""/>
          <p:cNvSpPr/>
          <p:nvPr/>
        </p:nvSpPr>
        <p:spPr>
          <a:xfrm>
            <a:off x="5041800" y="464040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4" name=""/>
          <p:cNvSpPr/>
          <p:nvPr/>
        </p:nvSpPr>
        <p:spPr>
          <a:xfrm>
            <a:off x="5105520" y="464040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5" name=""/>
          <p:cNvSpPr/>
          <p:nvPr/>
        </p:nvSpPr>
        <p:spPr>
          <a:xfrm>
            <a:off x="5221440" y="5407200"/>
            <a:ext cx="129528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onserved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hypothetical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346" name=""/>
          <p:cNvCxnSpPr>
            <a:stCxn id="345" idx="0"/>
            <a:endCxn id="344" idx="2"/>
          </p:cNvCxnSpPr>
          <p:nvPr/>
        </p:nvCxnSpPr>
        <p:spPr>
          <a:xfrm flipH="1" flipV="1">
            <a:off x="5314320" y="4878000"/>
            <a:ext cx="554760" cy="5292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228600" y="1447560"/>
            <a:ext cx="8763120" cy="510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Samples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3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3166 (AY714821), 3215 (AY714870), 3269 (AY327048)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4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(3218 - AY714873)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5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metagenome Eel River Bas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6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sediment, (520m / 9cm) dept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Longest extension with mismatches: </a:t>
            </a:r>
            <a:r>
              <a:rPr b="0" lang="de-DE" sz="2400" spc="-1" strike="noStrike">
                <a:solidFill>
                  <a:srgbClr val="000000"/>
                </a:solidFill>
                <a:latin typeface="Symbol"/>
                <a:ea typeface="Symbol"/>
              </a:rPr>
              <a:t></a:t>
            </a: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 length 9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182B721-7A6A-47CC-9C9D-3EE0A76924ED}" type="slidenum">
              <a:t>3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" name="PlaceHolder 1"/>
          <p:cNvSpPr>
            <a:spLocks noGrp="1"/>
          </p:cNvSpPr>
          <p:nvPr>
            <p:ph type="title"/>
          </p:nvPr>
        </p:nvSpPr>
        <p:spPr>
          <a:xfrm>
            <a:off x="685800" y="30456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mrtC - 17pattern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>
            <a:hlinkClick r:id="rId1" action="ppaction://hlinksldjump"/>
          </p:cNvPr>
          <p:cNvSpPr/>
          <p:nvPr/>
        </p:nvSpPr>
        <p:spPr>
          <a:xfrm>
            <a:off x="3657600" y="83808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10800"/>
                </a:moveTo>
                <a:lnTo>
                  <a:pt x="28556" y="3794"/>
                </a:lnTo>
                <a:lnTo>
                  <a:pt x="2855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0" name=""/>
          <p:cNvSpPr/>
          <p:nvPr/>
        </p:nvSpPr>
        <p:spPr>
          <a:xfrm>
            <a:off x="428760" y="4098960"/>
            <a:ext cx="1295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Transcriptinal regulator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1" name=""/>
          <p:cNvSpPr/>
          <p:nvPr/>
        </p:nvSpPr>
        <p:spPr>
          <a:xfrm>
            <a:off x="5495760" y="4114800"/>
            <a:ext cx="5335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trD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2" name=""/>
          <p:cNvSpPr/>
          <p:nvPr/>
        </p:nvSpPr>
        <p:spPr>
          <a:xfrm>
            <a:off x="5896080" y="4114800"/>
            <a:ext cx="5331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tr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3" name=""/>
          <p:cNvSpPr/>
          <p:nvPr/>
        </p:nvSpPr>
        <p:spPr>
          <a:xfrm>
            <a:off x="4572000" y="5013360"/>
            <a:ext cx="2209680" cy="703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7964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N5-methyl-tetrahydromethanopterin:coenzyme M methyltransferase,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7964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subunit E (mtrE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4" name=""/>
          <p:cNvSpPr/>
          <p:nvPr/>
        </p:nvSpPr>
        <p:spPr>
          <a:xfrm>
            <a:off x="136224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5" name=""/>
          <p:cNvSpPr/>
          <p:nvPr/>
        </p:nvSpPr>
        <p:spPr>
          <a:xfrm>
            <a:off x="178128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6" name=""/>
          <p:cNvSpPr/>
          <p:nvPr/>
        </p:nvSpPr>
        <p:spPr>
          <a:xfrm>
            <a:off x="220032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7" name=""/>
          <p:cNvSpPr/>
          <p:nvPr/>
        </p:nvSpPr>
        <p:spPr>
          <a:xfrm>
            <a:off x="261936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8" name=""/>
          <p:cNvSpPr/>
          <p:nvPr/>
        </p:nvSpPr>
        <p:spPr>
          <a:xfrm>
            <a:off x="303840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9" name=""/>
          <p:cNvSpPr/>
          <p:nvPr/>
        </p:nvSpPr>
        <p:spPr>
          <a:xfrm>
            <a:off x="3457440" y="3352680"/>
            <a:ext cx="41940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0" name=""/>
          <p:cNvSpPr/>
          <p:nvPr/>
        </p:nvSpPr>
        <p:spPr>
          <a:xfrm>
            <a:off x="387684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1" name=""/>
          <p:cNvSpPr/>
          <p:nvPr/>
        </p:nvSpPr>
        <p:spPr>
          <a:xfrm>
            <a:off x="429588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2" name=""/>
          <p:cNvSpPr/>
          <p:nvPr/>
        </p:nvSpPr>
        <p:spPr>
          <a:xfrm>
            <a:off x="471492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3" name=""/>
          <p:cNvSpPr/>
          <p:nvPr/>
        </p:nvSpPr>
        <p:spPr>
          <a:xfrm>
            <a:off x="513396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4" name=""/>
          <p:cNvSpPr/>
          <p:nvPr/>
        </p:nvSpPr>
        <p:spPr>
          <a:xfrm>
            <a:off x="555300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5" name=""/>
          <p:cNvSpPr/>
          <p:nvPr/>
        </p:nvSpPr>
        <p:spPr>
          <a:xfrm>
            <a:off x="5972040" y="3352680"/>
            <a:ext cx="41940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6" name=""/>
          <p:cNvSpPr/>
          <p:nvPr/>
        </p:nvSpPr>
        <p:spPr>
          <a:xfrm>
            <a:off x="639144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7" name=""/>
          <p:cNvSpPr/>
          <p:nvPr/>
        </p:nvSpPr>
        <p:spPr>
          <a:xfrm>
            <a:off x="681048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8" name=""/>
          <p:cNvSpPr/>
          <p:nvPr/>
        </p:nvSpPr>
        <p:spPr>
          <a:xfrm>
            <a:off x="722952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9" name=""/>
          <p:cNvSpPr/>
          <p:nvPr/>
        </p:nvSpPr>
        <p:spPr>
          <a:xfrm>
            <a:off x="764856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0" name=""/>
          <p:cNvSpPr/>
          <p:nvPr/>
        </p:nvSpPr>
        <p:spPr>
          <a:xfrm>
            <a:off x="8067600" y="335268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1" name=""/>
          <p:cNvSpPr/>
          <p:nvPr/>
        </p:nvSpPr>
        <p:spPr>
          <a:xfrm>
            <a:off x="382896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rt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2" name=""/>
          <p:cNvSpPr/>
          <p:nvPr/>
        </p:nvSpPr>
        <p:spPr>
          <a:xfrm>
            <a:off x="421956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3" name=""/>
          <p:cNvSpPr/>
          <p:nvPr/>
        </p:nvSpPr>
        <p:spPr>
          <a:xfrm>
            <a:off x="129528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4" name=""/>
          <p:cNvSpPr/>
          <p:nvPr/>
        </p:nvSpPr>
        <p:spPr>
          <a:xfrm>
            <a:off x="170496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5" name=""/>
          <p:cNvSpPr/>
          <p:nvPr/>
        </p:nvSpPr>
        <p:spPr>
          <a:xfrm>
            <a:off x="2133720" y="335268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6" name=""/>
          <p:cNvSpPr/>
          <p:nvPr/>
        </p:nvSpPr>
        <p:spPr>
          <a:xfrm>
            <a:off x="254304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7" name=""/>
          <p:cNvSpPr/>
          <p:nvPr/>
        </p:nvSpPr>
        <p:spPr>
          <a:xfrm>
            <a:off x="297180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8" name=""/>
          <p:cNvSpPr/>
          <p:nvPr/>
        </p:nvSpPr>
        <p:spPr>
          <a:xfrm>
            <a:off x="3381480" y="335268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9" name=""/>
          <p:cNvSpPr/>
          <p:nvPr/>
        </p:nvSpPr>
        <p:spPr>
          <a:xfrm>
            <a:off x="467676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0" name=""/>
          <p:cNvSpPr/>
          <p:nvPr/>
        </p:nvSpPr>
        <p:spPr>
          <a:xfrm>
            <a:off x="505764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1" name=""/>
          <p:cNvSpPr/>
          <p:nvPr/>
        </p:nvSpPr>
        <p:spPr>
          <a:xfrm>
            <a:off x="549576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2" name=""/>
          <p:cNvSpPr/>
          <p:nvPr/>
        </p:nvSpPr>
        <p:spPr>
          <a:xfrm>
            <a:off x="5896080" y="335268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3" name=""/>
          <p:cNvSpPr/>
          <p:nvPr/>
        </p:nvSpPr>
        <p:spPr>
          <a:xfrm>
            <a:off x="632448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4" name=""/>
          <p:cNvSpPr/>
          <p:nvPr/>
        </p:nvSpPr>
        <p:spPr>
          <a:xfrm>
            <a:off x="673416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5" name=""/>
          <p:cNvSpPr/>
          <p:nvPr/>
        </p:nvSpPr>
        <p:spPr>
          <a:xfrm>
            <a:off x="717228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6" name=""/>
          <p:cNvSpPr/>
          <p:nvPr/>
        </p:nvSpPr>
        <p:spPr>
          <a:xfrm>
            <a:off x="757224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7" name=""/>
          <p:cNvSpPr/>
          <p:nvPr/>
        </p:nvSpPr>
        <p:spPr>
          <a:xfrm>
            <a:off x="798192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1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8" name=""/>
          <p:cNvSpPr/>
          <p:nvPr/>
        </p:nvSpPr>
        <p:spPr>
          <a:xfrm>
            <a:off x="3581280" y="4495680"/>
            <a:ext cx="1447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geranylgeranylglyceryl diphosphate synthas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9" name=""/>
          <p:cNvSpPr/>
          <p:nvPr/>
        </p:nvSpPr>
        <p:spPr>
          <a:xfrm>
            <a:off x="4191120" y="4067280"/>
            <a:ext cx="1371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onserved hypothetical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0" name=""/>
          <p:cNvSpPr/>
          <p:nvPr/>
        </p:nvSpPr>
        <p:spPr>
          <a:xfrm>
            <a:off x="2343240" y="5105520"/>
            <a:ext cx="137160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SSU ribosomal protein S5P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391" name=""/>
          <p:cNvCxnSpPr>
            <a:stCxn id="350" idx="0"/>
            <a:endCxn id="373" idx="2"/>
          </p:cNvCxnSpPr>
          <p:nvPr/>
        </p:nvCxnSpPr>
        <p:spPr>
          <a:xfrm flipV="1">
            <a:off x="1076040" y="3596760"/>
            <a:ext cx="486360" cy="502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92" name=""/>
          <p:cNvCxnSpPr>
            <a:stCxn id="393" idx="0"/>
            <a:endCxn id="374" idx="2"/>
          </p:cNvCxnSpPr>
          <p:nvPr/>
        </p:nvCxnSpPr>
        <p:spPr>
          <a:xfrm flipH="1" flipV="1">
            <a:off x="1971360" y="3596760"/>
            <a:ext cx="10080" cy="8834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94" name=""/>
          <p:cNvSpPr/>
          <p:nvPr/>
        </p:nvSpPr>
        <p:spPr>
          <a:xfrm>
            <a:off x="2514600" y="4638600"/>
            <a:ext cx="5335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18p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395" name=""/>
          <p:cNvCxnSpPr>
            <a:stCxn id="394" idx="0"/>
            <a:endCxn id="375" idx="2"/>
          </p:cNvCxnSpPr>
          <p:nvPr/>
        </p:nvCxnSpPr>
        <p:spPr>
          <a:xfrm flipH="1" flipV="1">
            <a:off x="2400120" y="3596400"/>
            <a:ext cx="381600" cy="10422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96" name=""/>
          <p:cNvSpPr/>
          <p:nvPr/>
        </p:nvSpPr>
        <p:spPr>
          <a:xfrm>
            <a:off x="2952720" y="4638600"/>
            <a:ext cx="5335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30p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397" name=""/>
          <p:cNvCxnSpPr>
            <a:stCxn id="390" idx="0"/>
            <a:endCxn id="376" idx="2"/>
          </p:cNvCxnSpPr>
          <p:nvPr/>
        </p:nvCxnSpPr>
        <p:spPr>
          <a:xfrm flipH="1" flipV="1">
            <a:off x="2809080" y="3596760"/>
            <a:ext cx="219960" cy="150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98" name=""/>
          <p:cNvCxnSpPr>
            <a:stCxn id="396" idx="0"/>
            <a:endCxn id="377" idx="2"/>
          </p:cNvCxnSpPr>
          <p:nvPr/>
        </p:nvCxnSpPr>
        <p:spPr>
          <a:xfrm flipV="1">
            <a:off x="3219120" y="3596400"/>
            <a:ext cx="19800" cy="10422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99" name=""/>
          <p:cNvCxnSpPr>
            <a:stCxn id="388" idx="0"/>
            <a:endCxn id="378" idx="2"/>
          </p:cNvCxnSpPr>
          <p:nvPr/>
        </p:nvCxnSpPr>
        <p:spPr>
          <a:xfrm flipH="1" flipV="1">
            <a:off x="3647520" y="3596760"/>
            <a:ext cx="657720" cy="8992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93" name=""/>
          <p:cNvSpPr/>
          <p:nvPr/>
        </p:nvSpPr>
        <p:spPr>
          <a:xfrm>
            <a:off x="1143000" y="4479840"/>
            <a:ext cx="1676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LSU ribosomal proteins L19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400" name=""/>
          <p:cNvCxnSpPr>
            <a:stCxn id="389" idx="0"/>
            <a:endCxn id="372" idx="2"/>
          </p:cNvCxnSpPr>
          <p:nvPr/>
        </p:nvCxnSpPr>
        <p:spPr>
          <a:xfrm flipH="1" flipV="1">
            <a:off x="4485600" y="3596760"/>
            <a:ext cx="391320" cy="4708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01" name=""/>
          <p:cNvCxnSpPr>
            <a:stCxn id="389" idx="0"/>
            <a:endCxn id="379" idx="2"/>
          </p:cNvCxnSpPr>
          <p:nvPr/>
        </p:nvCxnSpPr>
        <p:spPr>
          <a:xfrm flipV="1">
            <a:off x="4876560" y="3596760"/>
            <a:ext cx="67320" cy="4708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02" name=""/>
          <p:cNvCxnSpPr>
            <a:stCxn id="353" idx="0"/>
            <a:endCxn id="380" idx="2"/>
          </p:cNvCxnSpPr>
          <p:nvPr/>
        </p:nvCxnSpPr>
        <p:spPr>
          <a:xfrm flipH="1" flipV="1">
            <a:off x="5323680" y="3596760"/>
            <a:ext cx="353160" cy="1416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03" name=""/>
          <p:cNvCxnSpPr>
            <a:stCxn id="351" idx="0"/>
            <a:endCxn id="381" idx="2"/>
          </p:cNvCxnSpPr>
          <p:nvPr/>
        </p:nvCxnSpPr>
        <p:spPr>
          <a:xfrm flipV="1">
            <a:off x="5762160" y="3596760"/>
            <a:ext cx="108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04" name=""/>
          <p:cNvCxnSpPr>
            <a:stCxn id="352" idx="0"/>
            <a:endCxn id="382" idx="2"/>
          </p:cNvCxnSpPr>
          <p:nvPr/>
        </p:nvCxnSpPr>
        <p:spPr>
          <a:xfrm flipV="1">
            <a:off x="6162480" y="3596760"/>
            <a:ext cx="108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05" name=""/>
          <p:cNvSpPr/>
          <p:nvPr/>
        </p:nvSpPr>
        <p:spPr>
          <a:xfrm>
            <a:off x="6362640" y="4114800"/>
            <a:ext cx="4572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trB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406" name=""/>
          <p:cNvCxnSpPr>
            <a:stCxn id="405" idx="0"/>
            <a:endCxn id="383" idx="2"/>
          </p:cNvCxnSpPr>
          <p:nvPr/>
        </p:nvCxnSpPr>
        <p:spPr>
          <a:xfrm flipV="1">
            <a:off x="6590880" y="3596760"/>
            <a:ext cx="108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07" name=""/>
          <p:cNvSpPr/>
          <p:nvPr/>
        </p:nvSpPr>
        <p:spPr>
          <a:xfrm>
            <a:off x="6734160" y="4114800"/>
            <a:ext cx="5335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tr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408" name=""/>
          <p:cNvCxnSpPr>
            <a:stCxn id="407" idx="0"/>
            <a:endCxn id="384" idx="2"/>
          </p:cNvCxnSpPr>
          <p:nvPr/>
        </p:nvCxnSpPr>
        <p:spPr>
          <a:xfrm flipV="1">
            <a:off x="7000560" y="3596760"/>
            <a:ext cx="108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09" name=""/>
          <p:cNvSpPr/>
          <p:nvPr/>
        </p:nvSpPr>
        <p:spPr>
          <a:xfrm>
            <a:off x="7172280" y="4118040"/>
            <a:ext cx="5335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tr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410" name=""/>
          <p:cNvCxnSpPr>
            <a:stCxn id="409" idx="0"/>
            <a:endCxn id="385" idx="2"/>
          </p:cNvCxnSpPr>
          <p:nvPr/>
        </p:nvCxnSpPr>
        <p:spPr>
          <a:xfrm flipV="1">
            <a:off x="7438680" y="3596400"/>
            <a:ext cx="1080" cy="5216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11" name=""/>
          <p:cNvSpPr/>
          <p:nvPr/>
        </p:nvSpPr>
        <p:spPr>
          <a:xfrm>
            <a:off x="7572240" y="4114800"/>
            <a:ext cx="5335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tr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412" name=""/>
          <p:cNvCxnSpPr>
            <a:stCxn id="411" idx="0"/>
            <a:endCxn id="386" idx="2"/>
          </p:cNvCxnSpPr>
          <p:nvPr/>
        </p:nvCxnSpPr>
        <p:spPr>
          <a:xfrm flipV="1">
            <a:off x="7838640" y="3596760"/>
            <a:ext cx="1080" cy="518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13" name=""/>
          <p:cNvSpPr/>
          <p:nvPr/>
        </p:nvSpPr>
        <p:spPr>
          <a:xfrm>
            <a:off x="7981920" y="4098960"/>
            <a:ext cx="5335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trH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414" name=""/>
          <p:cNvCxnSpPr>
            <a:stCxn id="413" idx="0"/>
            <a:endCxn id="387" idx="2"/>
          </p:cNvCxnSpPr>
          <p:nvPr/>
        </p:nvCxnSpPr>
        <p:spPr>
          <a:xfrm flipV="1">
            <a:off x="8248320" y="3596760"/>
            <a:ext cx="1080" cy="502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15" name="PlaceHolder 2"/>
          <p:cNvSpPr>
            <a:spLocks noGrp="1"/>
          </p:cNvSpPr>
          <p:nvPr>
            <p:ph/>
          </p:nvPr>
        </p:nvSpPr>
        <p:spPr>
          <a:xfrm>
            <a:off x="228240" y="1143000"/>
            <a:ext cx="8915400" cy="5410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Samples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3163 (AY714818), 3202 (AY714857), 3207 (AY714857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3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metagenome Eel River Bas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4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sediment, (520m / 9cm) dept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5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Length 17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19B6718-DC54-4B95-8DB2-C3D977E84360}" type="slidenum">
              <a:t>3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"/>
          <p:cNvSpPr/>
          <p:nvPr/>
        </p:nvSpPr>
        <p:spPr>
          <a:xfrm>
            <a:off x="6373800" y="3789360"/>
            <a:ext cx="2735280" cy="259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All Blast searches were carried out with threshold 1E-1.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Key genes: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1" marL="361800" indent="-182520">
              <a:lnSpc>
                <a:spcPct val="100000"/>
              </a:lnSpc>
              <a:spcBef>
                <a:spcPts val="451"/>
              </a:spcBef>
              <a:buSzPct val="102812"/>
              <a:buBlip>
                <a:blip r:embed="rId1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AAV95654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361800" indent="-182520">
              <a:lnSpc>
                <a:spcPct val="100000"/>
              </a:lnSpc>
              <a:spcBef>
                <a:spcPts val="451"/>
              </a:spcBef>
              <a:buSzPct val="102812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AAV94806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361800" indent="-182520">
              <a:lnSpc>
                <a:spcPct val="100000"/>
              </a:lnSpc>
              <a:spcBef>
                <a:spcPts val="451"/>
              </a:spcBef>
              <a:buSzPct val="102812"/>
              <a:buBlip>
                <a:blip r:embed="rId3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684360" y="25992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800" spc="-1" strike="noStrike">
                <a:solidFill>
                  <a:srgbClr val="000000"/>
                </a:solidFill>
                <a:latin typeface="Arial"/>
              </a:rPr>
              <a:t>Analysis of Cox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457200" y="1052280"/>
            <a:ext cx="8305920" cy="532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3333cc"/>
              </a:buClr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Key genes are taken from Moran MA, Miller WL. (2007) Resourceful heterotrophs make the most of light in the coastal ocean.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Nat Rev Microbiol. Oct;5(10):792-800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19" name="" descr=""/>
          <p:cNvPicPr/>
          <p:nvPr/>
        </p:nvPicPr>
        <p:blipFill>
          <a:blip r:embed="rId4"/>
          <a:stretch/>
        </p:blipFill>
        <p:spPr>
          <a:xfrm>
            <a:off x="985680" y="2492280"/>
            <a:ext cx="5241960" cy="3915000"/>
          </a:xfrm>
          <a:prstGeom prst="rect">
            <a:avLst/>
          </a:prstGeom>
          <a:ln w="0">
            <a:noFill/>
          </a:ln>
        </p:spPr>
      </p:pic>
      <p:sp>
        <p:nvSpPr>
          <p:cNvPr id="420" name=""/>
          <p:cNvSpPr/>
          <p:nvPr/>
        </p:nvSpPr>
        <p:spPr>
          <a:xfrm>
            <a:off x="5003640" y="6073920"/>
            <a:ext cx="432000" cy="0"/>
          </a:xfrm>
          <a:prstGeom prst="line">
            <a:avLst/>
          </a:prstGeom>
          <a:ln w="28440">
            <a:solidFill>
              <a:srgbClr val="fd1d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1" name=""/>
          <p:cNvSpPr/>
          <p:nvPr/>
        </p:nvSpPr>
        <p:spPr>
          <a:xfrm>
            <a:off x="5580000" y="6073920"/>
            <a:ext cx="432000" cy="0"/>
          </a:xfrm>
          <a:prstGeom prst="line">
            <a:avLst/>
          </a:prstGeom>
          <a:ln w="28440">
            <a:solidFill>
              <a:srgbClr val="fd1d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5409737-65D0-4FE2-9C10-20A796F3AA90}" type="slidenum">
              <a:t>3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2" name=""/>
          <p:cNvGrpSpPr/>
          <p:nvPr/>
        </p:nvGrpSpPr>
        <p:grpSpPr>
          <a:xfrm>
            <a:off x="103320" y="620640"/>
            <a:ext cx="8861400" cy="5421240"/>
            <a:chOff x="103320" y="620640"/>
            <a:chExt cx="8861400" cy="5421240"/>
          </a:xfrm>
        </p:grpSpPr>
        <p:pic>
          <p:nvPicPr>
            <p:cNvPr id="423" name="" descr=""/>
            <p:cNvPicPr/>
            <p:nvPr/>
          </p:nvPicPr>
          <p:blipFill>
            <a:blip r:embed="rId1"/>
            <a:stretch/>
          </p:blipFill>
          <p:spPr>
            <a:xfrm>
              <a:off x="103320" y="620640"/>
              <a:ext cx="8861400" cy="5421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24" name=""/>
            <p:cNvSpPr/>
            <p:nvPr/>
          </p:nvSpPr>
          <p:spPr>
            <a:xfrm>
              <a:off x="4092480" y="1100160"/>
              <a:ext cx="38102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coxL-AAV95654.1: 5a-pattern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192240" y="3784680"/>
              <a:ext cx="137160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fd1d1d"/>
                  </a:solidFill>
                  <a:latin typeface="Arial"/>
                </a:rPr>
                <a:t>carbon monoxide dehydrogenase (coxL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fd1d1d"/>
                  </a:solidFill>
                  <a:latin typeface="Arial"/>
                </a:rPr>
                <a:t>large subuni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204840" y="4653000"/>
              <a:ext cx="1371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fd1d1d"/>
                  </a:solidFill>
                  <a:latin typeface="Arial"/>
                </a:rPr>
                <a:t>middle subuni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185760" y="5013360"/>
              <a:ext cx="1371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fd1d1d"/>
                  </a:solidFill>
                  <a:latin typeface="Arial"/>
                </a:rPr>
                <a:t>small subuni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162000" y="3284640"/>
              <a:ext cx="13716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fd1d1d"/>
                  </a:solidFill>
                  <a:latin typeface="Arial"/>
                </a:rPr>
                <a:t>conserved hypothetical protei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1428840" y="3500280"/>
              <a:ext cx="1271520" cy="194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1428840" y="3500280"/>
              <a:ext cx="1055520" cy="194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1285920" y="4221000"/>
              <a:ext cx="909720" cy="1224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1357200" y="4795920"/>
              <a:ext cx="622440" cy="649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1285920" y="5156280"/>
              <a:ext cx="406440" cy="28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34" name=""/>
          <p:cNvSpPr/>
          <p:nvPr/>
        </p:nvSpPr>
        <p:spPr>
          <a:xfrm>
            <a:off x="7693200" y="1235160"/>
            <a:ext cx="304560" cy="15228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149" h="21600">
                <a:moveTo>
                  <a:pt x="0" y="0"/>
                </a:moveTo>
                <a:lnTo>
                  <a:pt x="43149" y="0"/>
                </a:lnTo>
                <a:lnTo>
                  <a:pt x="43149" y="21600"/>
                </a:lnTo>
                <a:lnTo>
                  <a:pt x="0" y="21600"/>
                </a:lnTo>
                <a:close/>
              </a:path>
              <a:path fill="lightenLess" w="43149" h="21600">
                <a:moveTo>
                  <a:pt x="0" y="0"/>
                </a:moveTo>
                <a:lnTo>
                  <a:pt x="43149" y="0"/>
                </a:lnTo>
                <a:lnTo>
                  <a:pt x="41749" y="1400"/>
                </a:lnTo>
                <a:lnTo>
                  <a:pt x="1400" y="1400"/>
                </a:lnTo>
                <a:close/>
              </a:path>
              <a:path fill="darken" w="43149" h="21600">
                <a:moveTo>
                  <a:pt x="43149" y="0"/>
                </a:moveTo>
                <a:lnTo>
                  <a:pt x="43149" y="21600"/>
                </a:lnTo>
                <a:lnTo>
                  <a:pt x="41749" y="20200"/>
                </a:lnTo>
                <a:lnTo>
                  <a:pt x="41749" y="1400"/>
                </a:lnTo>
                <a:close/>
              </a:path>
              <a:path fill="darkenLess" w="43149" h="21600">
                <a:moveTo>
                  <a:pt x="43149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749" y="20200"/>
                </a:lnTo>
                <a:close/>
              </a:path>
              <a:path fill="lighten" w="43149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149" h="21600">
                <a:moveTo>
                  <a:pt x="14568" y="3794"/>
                </a:moveTo>
                <a:lnTo>
                  <a:pt x="28581" y="10800"/>
                </a:lnTo>
                <a:lnTo>
                  <a:pt x="14568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B928A41-FBD7-452E-84FC-0F9B4A634404}" type="slidenum">
              <a:t>3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PlaceHolder 1"/>
          <p:cNvSpPr>
            <a:spLocks noGrp="1"/>
          </p:cNvSpPr>
          <p:nvPr>
            <p:ph type="title"/>
          </p:nvPr>
        </p:nvSpPr>
        <p:spPr>
          <a:xfrm>
            <a:off x="685800" y="30456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Arial"/>
              </a:rPr>
              <a:t>coxL – 5a-pattern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3657600" y="83808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10800"/>
                </a:moveTo>
                <a:lnTo>
                  <a:pt x="28556" y="3794"/>
                </a:lnTo>
                <a:lnTo>
                  <a:pt x="28556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7" name=""/>
          <p:cNvSpPr/>
          <p:nvPr/>
        </p:nvSpPr>
        <p:spPr>
          <a:xfrm>
            <a:off x="5219640" y="4884840"/>
            <a:ext cx="136836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ons. hypothetical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8" name=""/>
          <p:cNvSpPr/>
          <p:nvPr/>
        </p:nvSpPr>
        <p:spPr>
          <a:xfrm>
            <a:off x="3876840" y="380376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9" name=""/>
          <p:cNvSpPr/>
          <p:nvPr/>
        </p:nvSpPr>
        <p:spPr>
          <a:xfrm>
            <a:off x="4295880" y="380376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0" name=""/>
          <p:cNvSpPr/>
          <p:nvPr/>
        </p:nvSpPr>
        <p:spPr>
          <a:xfrm>
            <a:off x="4714920" y="380376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1" name=""/>
          <p:cNvSpPr/>
          <p:nvPr/>
        </p:nvSpPr>
        <p:spPr>
          <a:xfrm>
            <a:off x="5133960" y="380376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2" name=""/>
          <p:cNvSpPr/>
          <p:nvPr/>
        </p:nvSpPr>
        <p:spPr>
          <a:xfrm>
            <a:off x="5553000" y="3803760"/>
            <a:ext cx="419040" cy="228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3" name=""/>
          <p:cNvSpPr/>
          <p:nvPr/>
        </p:nvSpPr>
        <p:spPr>
          <a:xfrm>
            <a:off x="3828960" y="380376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4" name=""/>
          <p:cNvSpPr/>
          <p:nvPr/>
        </p:nvSpPr>
        <p:spPr>
          <a:xfrm>
            <a:off x="4219560" y="380376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5" name=""/>
          <p:cNvSpPr/>
          <p:nvPr/>
        </p:nvSpPr>
        <p:spPr>
          <a:xfrm>
            <a:off x="4676760" y="380376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oxL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6" name=""/>
          <p:cNvSpPr/>
          <p:nvPr/>
        </p:nvSpPr>
        <p:spPr>
          <a:xfrm>
            <a:off x="5057640" y="380376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7" name=""/>
          <p:cNvSpPr/>
          <p:nvPr/>
        </p:nvSpPr>
        <p:spPr>
          <a:xfrm>
            <a:off x="5495760" y="380376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8" name=""/>
          <p:cNvSpPr/>
          <p:nvPr/>
        </p:nvSpPr>
        <p:spPr>
          <a:xfrm>
            <a:off x="3635280" y="4751280"/>
            <a:ext cx="13716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arbon monoxide dehydrogenase middle subuni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449" name=""/>
          <p:cNvCxnSpPr>
            <a:stCxn id="448" idx="0"/>
            <a:endCxn id="444" idx="2"/>
          </p:cNvCxnSpPr>
          <p:nvPr/>
        </p:nvCxnSpPr>
        <p:spPr>
          <a:xfrm flipV="1">
            <a:off x="4320720" y="4047480"/>
            <a:ext cx="165960" cy="703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50" name=""/>
          <p:cNvCxnSpPr>
            <a:stCxn id="437" idx="0"/>
            <a:endCxn id="447" idx="2"/>
          </p:cNvCxnSpPr>
          <p:nvPr/>
        </p:nvCxnSpPr>
        <p:spPr>
          <a:xfrm flipH="1" flipV="1">
            <a:off x="5761800" y="4047840"/>
            <a:ext cx="142200" cy="837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51" name="PlaceHolder 2"/>
          <p:cNvSpPr>
            <a:spLocks noGrp="1"/>
          </p:cNvSpPr>
          <p:nvPr>
            <p:ph/>
          </p:nvPr>
        </p:nvSpPr>
        <p:spPr>
          <a:xfrm>
            <a:off x="228240" y="1143000"/>
            <a:ext cx="8915400" cy="5410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Samples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1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3023 (BA000043), 3029 (CR522870), 3043 (BA000002),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3045 (CP000155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2000" spc="-1" strike="noStrike">
                <a:solidFill>
                  <a:srgbClr val="000000"/>
                </a:solidFill>
                <a:latin typeface="Arial"/>
              </a:rPr>
              <a:t>Geobacillus kaustophilus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,</a:t>
            </a:r>
            <a:r>
              <a:rPr b="0" i="1" lang="de-DE" sz="2000" spc="-1" strike="noStrike">
                <a:solidFill>
                  <a:srgbClr val="000000"/>
                </a:solidFill>
                <a:latin typeface="Arial"/>
              </a:rPr>
              <a:t>Desulfotalea psychrophila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,  </a:t>
            </a:r>
            <a:r>
              <a:rPr b="0" i="1" lang="de-DE" sz="2000" spc="-1" strike="noStrike">
                <a:solidFill>
                  <a:srgbClr val="000000"/>
                </a:solidFill>
                <a:latin typeface="Arial"/>
              </a:rPr>
              <a:t>Aeropyrum pernix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K1, </a:t>
            </a:r>
            <a:r>
              <a:rPr b="0" i="1" lang="de-DE" sz="2000" spc="-1" strike="noStrike">
                <a:solidFill>
                  <a:srgbClr val="000000"/>
                </a:solidFill>
                <a:latin typeface="Arial"/>
              </a:rPr>
              <a:t>Hahella chejuensis</a:t>
            </a: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3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sediment, oceanwater (geothermal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SzPct val="102792"/>
              <a:buBlip>
                <a:blip r:embed="rId4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Arial"/>
              </a:rPr>
              <a:t>Length 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876240" y="3760920"/>
            <a:ext cx="2376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attern instance for 302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3" name=""/>
          <p:cNvSpPr/>
          <p:nvPr/>
        </p:nvSpPr>
        <p:spPr>
          <a:xfrm>
            <a:off x="2484360" y="4751280"/>
            <a:ext cx="13716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arbon monoxide dehydrogenase small subuni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4" name=""/>
          <p:cNvSpPr/>
          <p:nvPr/>
        </p:nvSpPr>
        <p:spPr>
          <a:xfrm flipV="1">
            <a:off x="3203640" y="4076280"/>
            <a:ext cx="863640" cy="647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5" name=""/>
          <p:cNvSpPr/>
          <p:nvPr/>
        </p:nvSpPr>
        <p:spPr>
          <a:xfrm>
            <a:off x="4280040" y="5500800"/>
            <a:ext cx="13716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arbon monoxide dehydrogenase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large subuni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6" name=""/>
          <p:cNvSpPr/>
          <p:nvPr/>
        </p:nvSpPr>
        <p:spPr>
          <a:xfrm flipV="1">
            <a:off x="4932360" y="4005000"/>
            <a:ext cx="0" cy="1439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457" name=""/>
          <p:cNvCxnSpPr>
            <a:stCxn id="451" idx="2"/>
            <a:endCxn id="451" idx="2"/>
          </p:cNvCxnSpPr>
          <p:nvPr/>
        </p:nvCxnSpPr>
        <p:spPr>
          <a:xfrm>
            <a:off x="4686120" y="6552720"/>
            <a:ext cx="108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58" name=""/>
          <p:cNvCxnSpPr>
            <a:stCxn id="451" idx="2"/>
            <a:endCxn id="451" idx="2"/>
          </p:cNvCxnSpPr>
          <p:nvPr/>
        </p:nvCxnSpPr>
        <p:spPr>
          <a:xfrm>
            <a:off x="4686120" y="6552720"/>
            <a:ext cx="108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59" name=""/>
          <p:cNvCxnSpPr>
            <a:stCxn id="451" idx="2"/>
            <a:endCxn id="451" idx="2"/>
          </p:cNvCxnSpPr>
          <p:nvPr/>
        </p:nvCxnSpPr>
        <p:spPr>
          <a:xfrm>
            <a:off x="4686120" y="6552720"/>
            <a:ext cx="108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60" name=""/>
          <p:cNvSpPr/>
          <p:nvPr/>
        </p:nvSpPr>
        <p:spPr>
          <a:xfrm flipH="1" flipV="1">
            <a:off x="5364000" y="4076280"/>
            <a:ext cx="503280" cy="792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2F216A5-3A27-428D-B0D7-E7F1B7E7AF31}" type="slidenum">
              <a:t>3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1" name="" descr=""/>
          <p:cNvPicPr/>
          <p:nvPr/>
        </p:nvPicPr>
        <p:blipFill>
          <a:blip r:embed="rId1"/>
          <a:stretch/>
        </p:blipFill>
        <p:spPr>
          <a:xfrm>
            <a:off x="82440" y="260280"/>
            <a:ext cx="8985240" cy="5508720"/>
          </a:xfrm>
          <a:prstGeom prst="rect">
            <a:avLst/>
          </a:prstGeom>
          <a:ln w="0">
            <a:noFill/>
          </a:ln>
        </p:spPr>
      </p:pic>
      <p:sp>
        <p:nvSpPr>
          <p:cNvPr id="462" name=""/>
          <p:cNvSpPr/>
          <p:nvPr/>
        </p:nvSpPr>
        <p:spPr>
          <a:xfrm>
            <a:off x="4206960" y="73188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oxL-AAV95654.1: 5b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3" name=""/>
          <p:cNvSpPr/>
          <p:nvPr/>
        </p:nvSpPr>
        <p:spPr>
          <a:xfrm>
            <a:off x="160200" y="456084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large subuni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4" name=""/>
          <p:cNvSpPr/>
          <p:nvPr/>
        </p:nvSpPr>
        <p:spPr>
          <a:xfrm>
            <a:off x="179280" y="3500280"/>
            <a:ext cx="13716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carbon monoxide dehydrogenas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middle subuni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5" name=""/>
          <p:cNvSpPr/>
          <p:nvPr/>
        </p:nvSpPr>
        <p:spPr>
          <a:xfrm>
            <a:off x="160200" y="418788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small subuni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6" name=""/>
          <p:cNvSpPr/>
          <p:nvPr/>
        </p:nvSpPr>
        <p:spPr>
          <a:xfrm>
            <a:off x="160200" y="4856040"/>
            <a:ext cx="1371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conserved hypothetical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7" name=""/>
          <p:cNvSpPr/>
          <p:nvPr/>
        </p:nvSpPr>
        <p:spPr>
          <a:xfrm>
            <a:off x="250920" y="580536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coxS like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8" name=""/>
          <p:cNvSpPr/>
          <p:nvPr/>
        </p:nvSpPr>
        <p:spPr>
          <a:xfrm>
            <a:off x="1332000" y="4724280"/>
            <a:ext cx="647640" cy="433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9" name=""/>
          <p:cNvSpPr/>
          <p:nvPr/>
        </p:nvSpPr>
        <p:spPr>
          <a:xfrm flipV="1">
            <a:off x="1476360" y="5516640"/>
            <a:ext cx="2879640" cy="433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0" name=""/>
          <p:cNvSpPr/>
          <p:nvPr/>
        </p:nvSpPr>
        <p:spPr>
          <a:xfrm>
            <a:off x="1332000" y="4365720"/>
            <a:ext cx="863640" cy="792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1" name=""/>
          <p:cNvSpPr/>
          <p:nvPr/>
        </p:nvSpPr>
        <p:spPr>
          <a:xfrm>
            <a:off x="1403280" y="3789360"/>
            <a:ext cx="1081080" cy="1368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2" name=""/>
          <p:cNvSpPr/>
          <p:nvPr/>
        </p:nvSpPr>
        <p:spPr>
          <a:xfrm>
            <a:off x="1332000" y="5013360"/>
            <a:ext cx="360360" cy="144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3" name=""/>
          <p:cNvSpPr/>
          <p:nvPr/>
        </p:nvSpPr>
        <p:spPr>
          <a:xfrm flipV="1">
            <a:off x="1476360" y="5373360"/>
            <a:ext cx="1943280" cy="576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9526046-03FD-41DD-9D15-C04CA8657E6F}" type="slidenum">
              <a:t>3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4" name="" descr=""/>
          <p:cNvPicPr/>
          <p:nvPr/>
        </p:nvPicPr>
        <p:blipFill>
          <a:blip r:embed="rId1"/>
          <a:stretch/>
        </p:blipFill>
        <p:spPr>
          <a:xfrm>
            <a:off x="82440" y="385920"/>
            <a:ext cx="8964720" cy="5491080"/>
          </a:xfrm>
          <a:prstGeom prst="rect">
            <a:avLst/>
          </a:prstGeom>
          <a:ln w="0">
            <a:noFill/>
          </a:ln>
        </p:spPr>
      </p:pic>
      <p:sp>
        <p:nvSpPr>
          <p:cNvPr id="475" name=""/>
          <p:cNvSpPr/>
          <p:nvPr/>
        </p:nvSpPr>
        <p:spPr>
          <a:xfrm>
            <a:off x="4181400" y="846000"/>
            <a:ext cx="3810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oxL-AAV95654.1: 5c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6" name=""/>
          <p:cNvSpPr/>
          <p:nvPr/>
        </p:nvSpPr>
        <p:spPr>
          <a:xfrm>
            <a:off x="108000" y="4175280"/>
            <a:ext cx="1371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conserved hypothetical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7" name=""/>
          <p:cNvSpPr/>
          <p:nvPr/>
        </p:nvSpPr>
        <p:spPr>
          <a:xfrm>
            <a:off x="131760" y="464832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large subuni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8" name=""/>
          <p:cNvSpPr/>
          <p:nvPr/>
        </p:nvSpPr>
        <p:spPr>
          <a:xfrm>
            <a:off x="108000" y="4903920"/>
            <a:ext cx="1371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conserved hypothetical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9" name=""/>
          <p:cNvSpPr/>
          <p:nvPr/>
        </p:nvSpPr>
        <p:spPr>
          <a:xfrm>
            <a:off x="119160" y="385776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coxL like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0" name=""/>
          <p:cNvSpPr/>
          <p:nvPr/>
        </p:nvSpPr>
        <p:spPr>
          <a:xfrm>
            <a:off x="119160" y="350028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coxS like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1" name=""/>
          <p:cNvSpPr/>
          <p:nvPr/>
        </p:nvSpPr>
        <p:spPr>
          <a:xfrm>
            <a:off x="1332000" y="5084640"/>
            <a:ext cx="36036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2" name=""/>
          <p:cNvSpPr/>
          <p:nvPr/>
        </p:nvSpPr>
        <p:spPr>
          <a:xfrm>
            <a:off x="1258920" y="4797360"/>
            <a:ext cx="720720" cy="503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3" name=""/>
          <p:cNvSpPr/>
          <p:nvPr/>
        </p:nvSpPr>
        <p:spPr>
          <a:xfrm>
            <a:off x="1332000" y="4365720"/>
            <a:ext cx="2519280" cy="93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4" name=""/>
          <p:cNvSpPr/>
          <p:nvPr/>
        </p:nvSpPr>
        <p:spPr>
          <a:xfrm>
            <a:off x="1332000" y="4005360"/>
            <a:ext cx="2808360" cy="1295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5" name=""/>
          <p:cNvSpPr/>
          <p:nvPr/>
        </p:nvSpPr>
        <p:spPr>
          <a:xfrm>
            <a:off x="1332000" y="3645000"/>
            <a:ext cx="3095640" cy="1655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5CA7B79-333F-4AE2-BBC7-DEEF3727E0AF}" type="slidenum">
              <a:t>3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6" name="" descr=""/>
          <p:cNvPicPr/>
          <p:nvPr/>
        </p:nvPicPr>
        <p:blipFill>
          <a:blip r:embed="rId1"/>
          <a:stretch/>
        </p:blipFill>
        <p:spPr>
          <a:xfrm>
            <a:off x="108000" y="412920"/>
            <a:ext cx="8918640" cy="5464080"/>
          </a:xfrm>
          <a:prstGeom prst="rect">
            <a:avLst/>
          </a:prstGeom>
          <a:ln w="0">
            <a:noFill/>
          </a:ln>
        </p:spPr>
      </p:pic>
      <p:sp>
        <p:nvSpPr>
          <p:cNvPr id="487" name=""/>
          <p:cNvSpPr/>
          <p:nvPr/>
        </p:nvSpPr>
        <p:spPr>
          <a:xfrm>
            <a:off x="4079880" y="85896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oxL-AAV94806: 5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8" name=""/>
          <p:cNvSpPr/>
          <p:nvPr/>
        </p:nvSpPr>
        <p:spPr>
          <a:xfrm>
            <a:off x="235080" y="3611520"/>
            <a:ext cx="13716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carbon monoxide dehydrogenase (coxL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large subuni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9" name=""/>
          <p:cNvSpPr/>
          <p:nvPr/>
        </p:nvSpPr>
        <p:spPr>
          <a:xfrm>
            <a:off x="247680" y="447984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middle subuni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0" name=""/>
          <p:cNvSpPr/>
          <p:nvPr/>
        </p:nvSpPr>
        <p:spPr>
          <a:xfrm>
            <a:off x="228600" y="484020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small subuni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1" name=""/>
          <p:cNvSpPr/>
          <p:nvPr/>
        </p:nvSpPr>
        <p:spPr>
          <a:xfrm>
            <a:off x="204840" y="3111480"/>
            <a:ext cx="1371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fd1d1d"/>
                </a:solidFill>
                <a:latin typeface="Arial"/>
              </a:rPr>
              <a:t>conserved hypothetical prote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2" name=""/>
          <p:cNvSpPr/>
          <p:nvPr/>
        </p:nvSpPr>
        <p:spPr>
          <a:xfrm>
            <a:off x="1332000" y="5013360"/>
            <a:ext cx="36036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3" name=""/>
          <p:cNvSpPr/>
          <p:nvPr/>
        </p:nvSpPr>
        <p:spPr>
          <a:xfrm>
            <a:off x="1403280" y="4653000"/>
            <a:ext cx="576360" cy="647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4" name=""/>
          <p:cNvSpPr/>
          <p:nvPr/>
        </p:nvSpPr>
        <p:spPr>
          <a:xfrm>
            <a:off x="1403280" y="4076640"/>
            <a:ext cx="865080" cy="1224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5" name=""/>
          <p:cNvSpPr/>
          <p:nvPr/>
        </p:nvSpPr>
        <p:spPr>
          <a:xfrm>
            <a:off x="1403280" y="3284640"/>
            <a:ext cx="1081080" cy="20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6" name=""/>
          <p:cNvSpPr/>
          <p:nvPr/>
        </p:nvSpPr>
        <p:spPr>
          <a:xfrm>
            <a:off x="1403280" y="3284640"/>
            <a:ext cx="1297080" cy="20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4E7EAF8-563E-4C71-90A8-FA56243F0A64}" type="slidenum">
              <a:t>3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446040" y="47520"/>
            <a:ext cx="8207280" cy="6661080"/>
          </a:xfrm>
          <a:prstGeom prst="rect">
            <a:avLst/>
          </a:prstGeom>
          <a:ln w="0">
            <a:noFill/>
          </a:ln>
        </p:spPr>
      </p:pic>
      <p:sp>
        <p:nvSpPr>
          <p:cNvPr id="60" name="">
            <a:hlinkClick r:id="rId2" action="ppaction://hlinksldjump"/>
          </p:cNvPr>
          <p:cNvSpPr/>
          <p:nvPr/>
        </p:nvSpPr>
        <p:spPr>
          <a:xfrm>
            <a:off x="522360" y="6338880"/>
            <a:ext cx="304560" cy="15228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149" h="21600">
                <a:moveTo>
                  <a:pt x="0" y="0"/>
                </a:moveTo>
                <a:lnTo>
                  <a:pt x="43149" y="0"/>
                </a:lnTo>
                <a:lnTo>
                  <a:pt x="43149" y="21600"/>
                </a:lnTo>
                <a:lnTo>
                  <a:pt x="0" y="21600"/>
                </a:lnTo>
                <a:close/>
              </a:path>
              <a:path fill="lightenLess" w="43149" h="21600">
                <a:moveTo>
                  <a:pt x="0" y="0"/>
                </a:moveTo>
                <a:lnTo>
                  <a:pt x="43149" y="0"/>
                </a:lnTo>
                <a:lnTo>
                  <a:pt x="41749" y="1400"/>
                </a:lnTo>
                <a:lnTo>
                  <a:pt x="1400" y="1400"/>
                </a:lnTo>
                <a:close/>
              </a:path>
              <a:path fill="darken" w="43149" h="21600">
                <a:moveTo>
                  <a:pt x="43149" y="0"/>
                </a:moveTo>
                <a:lnTo>
                  <a:pt x="43149" y="21600"/>
                </a:lnTo>
                <a:lnTo>
                  <a:pt x="41749" y="20200"/>
                </a:lnTo>
                <a:lnTo>
                  <a:pt x="41749" y="1400"/>
                </a:lnTo>
                <a:close/>
              </a:path>
              <a:path fill="darkenLess" w="43149" h="21600">
                <a:moveTo>
                  <a:pt x="43149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749" y="20200"/>
                </a:lnTo>
                <a:close/>
              </a:path>
              <a:path fill="lighten" w="43149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149" h="21600">
                <a:moveTo>
                  <a:pt x="14568" y="10800"/>
                </a:moveTo>
                <a:lnTo>
                  <a:pt x="28581" y="3794"/>
                </a:lnTo>
                <a:lnTo>
                  <a:pt x="28581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4010040" y="511200"/>
            <a:ext cx="3429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A-AAC43406: 14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>
            <a:hlinkClick r:id="rId3" action="ppaction://hlinksldjump"/>
          </p:cNvPr>
          <p:cNvSpPr/>
          <p:nvPr/>
        </p:nvSpPr>
        <p:spPr>
          <a:xfrm>
            <a:off x="7362720" y="663480"/>
            <a:ext cx="304920" cy="15264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98" h="21600">
                <a:moveTo>
                  <a:pt x="0" y="0"/>
                </a:moveTo>
                <a:lnTo>
                  <a:pt x="43098" y="0"/>
                </a:lnTo>
                <a:lnTo>
                  <a:pt x="43098" y="21600"/>
                </a:lnTo>
                <a:lnTo>
                  <a:pt x="0" y="21600"/>
                </a:lnTo>
                <a:close/>
              </a:path>
              <a:path fill="lightenLess" w="43098" h="21600">
                <a:moveTo>
                  <a:pt x="0" y="0"/>
                </a:moveTo>
                <a:lnTo>
                  <a:pt x="43098" y="0"/>
                </a:lnTo>
                <a:lnTo>
                  <a:pt x="41698" y="1400"/>
                </a:lnTo>
                <a:lnTo>
                  <a:pt x="1400" y="1400"/>
                </a:lnTo>
                <a:close/>
              </a:path>
              <a:path fill="darken" w="43098" h="21600">
                <a:moveTo>
                  <a:pt x="43098" y="0"/>
                </a:moveTo>
                <a:lnTo>
                  <a:pt x="43098" y="21600"/>
                </a:lnTo>
                <a:lnTo>
                  <a:pt x="41698" y="20200"/>
                </a:lnTo>
                <a:lnTo>
                  <a:pt x="41698" y="1400"/>
                </a:lnTo>
                <a:close/>
              </a:path>
              <a:path fill="darkenLess" w="43098" h="21600">
                <a:moveTo>
                  <a:pt x="4309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98" y="20200"/>
                </a:lnTo>
                <a:close/>
              </a:path>
              <a:path fill="lighten" w="4309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98" h="21600">
                <a:moveTo>
                  <a:pt x="14543" y="3794"/>
                </a:moveTo>
                <a:lnTo>
                  <a:pt x="28556" y="10800"/>
                </a:lnTo>
                <a:lnTo>
                  <a:pt x="14543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8177DAB-1FB4-4A21-960F-CEBEA1479DB8}" type="slidenum">
              <a:t>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" descr=""/>
          <p:cNvPicPr/>
          <p:nvPr/>
        </p:nvPicPr>
        <p:blipFill>
          <a:blip r:embed="rId1"/>
          <a:stretch/>
        </p:blipFill>
        <p:spPr>
          <a:xfrm>
            <a:off x="506520" y="104760"/>
            <a:ext cx="8137440" cy="660240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4054320" y="536400"/>
            <a:ext cx="3429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A-AAC43406: 11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>
            <a:hlinkClick r:id="rId2" action="ppaction://hlinksldjump"/>
          </p:cNvPr>
          <p:cNvSpPr/>
          <p:nvPr/>
        </p:nvSpPr>
        <p:spPr>
          <a:xfrm>
            <a:off x="7559640" y="68904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B7817A3-D216-4727-9459-195CA3388F52}" type="slidenum">
              <a:t>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539640" y="109440"/>
            <a:ext cx="8064720" cy="6546960"/>
          </a:xfrm>
          <a:prstGeom prst="rect">
            <a:avLst/>
          </a:prstGeom>
          <a:ln w="0">
            <a:noFill/>
          </a:ln>
        </p:spPr>
      </p:pic>
      <p:sp>
        <p:nvSpPr>
          <p:cNvPr id="67" name=""/>
          <p:cNvSpPr/>
          <p:nvPr/>
        </p:nvSpPr>
        <p:spPr>
          <a:xfrm>
            <a:off x="4022640" y="528480"/>
            <a:ext cx="3429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Times New Roman"/>
              </a:rPr>
              <a:t>mcrA - AAC43406: 5a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>
            <a:hlinkClick r:id="rId2" action="ppaction://hlinksldjump"/>
          </p:cNvPr>
          <p:cNvSpPr/>
          <p:nvPr/>
        </p:nvSpPr>
        <p:spPr>
          <a:xfrm>
            <a:off x="7451640" y="68112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DB920DC-17F4-49EB-8CE4-D4B87E42631B}" type="slidenum">
              <a:t>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" descr=""/>
          <p:cNvPicPr/>
          <p:nvPr/>
        </p:nvPicPr>
        <p:blipFill>
          <a:blip r:embed="rId1"/>
          <a:stretch/>
        </p:blipFill>
        <p:spPr>
          <a:xfrm>
            <a:off x="595440" y="142920"/>
            <a:ext cx="8064360" cy="6546960"/>
          </a:xfrm>
          <a:prstGeom prst="rect">
            <a:avLst/>
          </a:prstGeom>
          <a:ln w="0">
            <a:noFill/>
          </a:ln>
        </p:spPr>
      </p:pic>
      <p:sp>
        <p:nvSpPr>
          <p:cNvPr id="70" name=""/>
          <p:cNvSpPr/>
          <p:nvPr/>
        </p:nvSpPr>
        <p:spPr>
          <a:xfrm>
            <a:off x="4111560" y="549360"/>
            <a:ext cx="3429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A-AAC43406: 5b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>
            <a:hlinkClick r:id="rId2" action="ppaction://hlinksldjump"/>
          </p:cNvPr>
          <p:cNvSpPr/>
          <p:nvPr/>
        </p:nvSpPr>
        <p:spPr>
          <a:xfrm>
            <a:off x="7616880" y="70164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B9AC3A2-7BA6-4560-B2D5-4A84373ABA59}" type="slidenum">
              <a:t>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" descr=""/>
          <p:cNvPicPr/>
          <p:nvPr/>
        </p:nvPicPr>
        <p:blipFill>
          <a:blip r:embed="rId1"/>
          <a:stretch/>
        </p:blipFill>
        <p:spPr>
          <a:xfrm>
            <a:off x="501480" y="138240"/>
            <a:ext cx="8064720" cy="6538680"/>
          </a:xfrm>
          <a:prstGeom prst="rect">
            <a:avLst/>
          </a:prstGeom>
          <a:ln w="0">
            <a:noFill/>
          </a:ln>
        </p:spPr>
      </p:pic>
      <p:sp>
        <p:nvSpPr>
          <p:cNvPr id="73" name="">
            <a:hlinkClick r:id="rId2" action="ppaction://hlinksldjump"/>
          </p:cNvPr>
          <p:cNvSpPr/>
          <p:nvPr/>
        </p:nvSpPr>
        <p:spPr>
          <a:xfrm>
            <a:off x="646200" y="6300720"/>
            <a:ext cx="304560" cy="152640"/>
          </a:xfrm>
          <a:custGeom>
            <a:avLst/>
            <a:gdLst>
              <a:gd name="textAreaLeft" fmla="*/ 9720 w 304560"/>
              <a:gd name="textAreaRight" fmla="*/ 294840 w 304560"/>
              <a:gd name="textAreaTop" fmla="*/ 9720 h 152640"/>
              <a:gd name="textAreaBottom" fmla="*/ 142920 h 152640"/>
            </a:gdLst>
            <a:ahLst/>
            <a:rect l="textAreaLeft" t="textAreaTop" r="textAreaRight" b="textAreaBottom"/>
            <a:pathLst>
              <a:path w="43048" h="21600">
                <a:moveTo>
                  <a:pt x="0" y="0"/>
                </a:moveTo>
                <a:lnTo>
                  <a:pt x="43048" y="0"/>
                </a:lnTo>
                <a:lnTo>
                  <a:pt x="43048" y="21600"/>
                </a:lnTo>
                <a:lnTo>
                  <a:pt x="0" y="21600"/>
                </a:lnTo>
                <a:close/>
              </a:path>
              <a:path fill="lightenLess" w="43048" h="21600">
                <a:moveTo>
                  <a:pt x="0" y="0"/>
                </a:moveTo>
                <a:lnTo>
                  <a:pt x="43048" y="0"/>
                </a:lnTo>
                <a:lnTo>
                  <a:pt x="41648" y="1400"/>
                </a:lnTo>
                <a:lnTo>
                  <a:pt x="1400" y="1400"/>
                </a:lnTo>
                <a:close/>
              </a:path>
              <a:path fill="darken" w="43048" h="21600">
                <a:moveTo>
                  <a:pt x="43048" y="0"/>
                </a:moveTo>
                <a:lnTo>
                  <a:pt x="43048" y="21600"/>
                </a:lnTo>
                <a:lnTo>
                  <a:pt x="41648" y="20200"/>
                </a:lnTo>
                <a:lnTo>
                  <a:pt x="41648" y="1400"/>
                </a:lnTo>
                <a:close/>
              </a:path>
              <a:path fill="darkenLess" w="43048" h="21600">
                <a:moveTo>
                  <a:pt x="4304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648" y="20200"/>
                </a:lnTo>
                <a:close/>
              </a:path>
              <a:path fill="lighten" w="4304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048" h="21600">
                <a:moveTo>
                  <a:pt x="14517" y="10800"/>
                </a:moveTo>
                <a:lnTo>
                  <a:pt x="28530" y="3794"/>
                </a:lnTo>
                <a:lnTo>
                  <a:pt x="28530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3898800" y="549360"/>
            <a:ext cx="3810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A-AAM30936: 14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>
            <a:hlinkClick r:id="rId3" action="ppaction://hlinksldjump"/>
          </p:cNvPr>
          <p:cNvSpPr/>
          <p:nvPr/>
        </p:nvSpPr>
        <p:spPr>
          <a:xfrm>
            <a:off x="7632720" y="70164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1A20E88-3C5A-4D26-A1E6-B74C4C9BB329}" type="slidenum">
              <a:t>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" descr=""/>
          <p:cNvPicPr/>
          <p:nvPr/>
        </p:nvPicPr>
        <p:blipFill>
          <a:blip r:embed="rId1"/>
          <a:stretch/>
        </p:blipFill>
        <p:spPr>
          <a:xfrm>
            <a:off x="595440" y="155520"/>
            <a:ext cx="7991280" cy="6491520"/>
          </a:xfrm>
          <a:prstGeom prst="rect">
            <a:avLst/>
          </a:prstGeom>
          <a:ln w="0">
            <a:noFill/>
          </a:ln>
        </p:spPr>
      </p:pic>
      <p:sp>
        <p:nvSpPr>
          <p:cNvPr id="77" name=""/>
          <p:cNvSpPr/>
          <p:nvPr/>
        </p:nvSpPr>
        <p:spPr>
          <a:xfrm>
            <a:off x="3898800" y="555480"/>
            <a:ext cx="3810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crA-AAM30936: 11-patter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>
            <a:hlinkClick r:id="rId2" action="ppaction://hlinksldjump"/>
          </p:cNvPr>
          <p:cNvSpPr/>
          <p:nvPr/>
        </p:nvSpPr>
        <p:spPr>
          <a:xfrm>
            <a:off x="7556400" y="708120"/>
            <a:ext cx="304920" cy="152280"/>
          </a:xfrm>
          <a:custGeom>
            <a:avLst/>
            <a:gdLst>
              <a:gd name="textAreaLeft" fmla="*/ 9720 w 304920"/>
              <a:gd name="textAreaRight" fmla="*/ 295200 w 304920"/>
              <a:gd name="textAreaTop" fmla="*/ 9720 h 152280"/>
              <a:gd name="textAreaBottom" fmla="*/ 142560 h 152280"/>
            </a:gdLst>
            <a:ahLst/>
            <a:rect l="textAreaLeft" t="textAreaTop" r="textAreaRight" b="textAreaBottom"/>
            <a:pathLst>
              <a:path w="43200" h="21600">
                <a:moveTo>
                  <a:pt x="0" y="0"/>
                </a:moveTo>
                <a:lnTo>
                  <a:pt x="43200" y="0"/>
                </a:lnTo>
                <a:lnTo>
                  <a:pt x="43200" y="21600"/>
                </a:lnTo>
                <a:lnTo>
                  <a:pt x="0" y="21600"/>
                </a:lnTo>
                <a:close/>
              </a:path>
              <a:path fill="lightenLess" w="43200" h="21600">
                <a:moveTo>
                  <a:pt x="0" y="0"/>
                </a:moveTo>
                <a:lnTo>
                  <a:pt x="43200" y="0"/>
                </a:lnTo>
                <a:lnTo>
                  <a:pt x="41800" y="1400"/>
                </a:lnTo>
                <a:lnTo>
                  <a:pt x="1400" y="1400"/>
                </a:lnTo>
                <a:close/>
              </a:path>
              <a:path fill="darken" w="43200" h="21600">
                <a:moveTo>
                  <a:pt x="43200" y="0"/>
                </a:moveTo>
                <a:lnTo>
                  <a:pt x="43200" y="21600"/>
                </a:lnTo>
                <a:lnTo>
                  <a:pt x="41800" y="20200"/>
                </a:lnTo>
                <a:lnTo>
                  <a:pt x="41800" y="1400"/>
                </a:lnTo>
                <a:close/>
              </a:path>
              <a:path fill="darkenLess" w="43200" h="21600">
                <a:moveTo>
                  <a:pt x="43200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41800" y="20200"/>
                </a:lnTo>
                <a:close/>
              </a:path>
              <a:path fill="lighten" w="43200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43200" h="21600">
                <a:moveTo>
                  <a:pt x="14594" y="3794"/>
                </a:moveTo>
                <a:lnTo>
                  <a:pt x="28606" y="10800"/>
                </a:lnTo>
                <a:lnTo>
                  <a:pt x="14594" y="17806"/>
                </a:lnTo>
                <a:close/>
              </a:path>
            </a:pathLst>
          </a:cu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D06B003-5F78-4682-900A-FF3B12FA456B}" type="slidenum">
              <a:t>9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9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2-11-01T13:36:51Z</dcterms:created>
  <dc:creator>bohnebeck</dc:creator>
  <dc:description/>
  <dc:language>en-US</dc:language>
  <cp:lastModifiedBy>bohnebeck</cp:lastModifiedBy>
  <dcterms:modified xsi:type="dcterms:W3CDTF">2008-07-09T10:14:16Z</dcterms:modified>
  <cp:revision>919</cp:revision>
  <dc:subject/>
  <dc:title>Technolgie-Transfer-Zentrum Ausrichtung Bioinformatik</dc:title>
</cp:coreProperties>
</file>